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57" r:id="rId3"/>
    <p:sldId id="260" r:id="rId4"/>
    <p:sldId id="259" r:id="rId5"/>
    <p:sldId id="256" r:id="rId6"/>
    <p:sldId id="261" r:id="rId7"/>
    <p:sldId id="262" r:id="rId8"/>
  </p:sldIdLst>
  <p:sldSz cx="9906000" cy="6858000" type="A4"/>
  <p:notesSz cx="6797675" cy="9926638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1230" userDrawn="1">
          <p15:clr>
            <a:srgbClr val="A4A3A4"/>
          </p15:clr>
        </p15:guide>
        <p15:guide id="2" pos="112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964" autoAdjust="0"/>
    <p:restoredTop sz="94660"/>
  </p:normalViewPr>
  <p:slideViewPr>
    <p:cSldViewPr snapToGrid="0" showGuides="1">
      <p:cViewPr>
        <p:scale>
          <a:sx n="100" d="100"/>
          <a:sy n="100" d="100"/>
        </p:scale>
        <p:origin x="-822" y="-174"/>
      </p:cViewPr>
      <p:guideLst>
        <p:guide orient="horz" pos="1110"/>
        <p:guide pos="2515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UPSLAB_2\Google%20&#46300;&#46972;&#51060;&#48652;\SY\CEBPb\C%20EBPb-Axin1%20&#51204;&#45804;\&#45436;&#47928;%20&#51088;&#47308;\&#45436;&#47928;%20&#44536;&#47548;\Fig.%203\Fig.%203A,F_131125_3T3-L1%20MDI_Wnt%20components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D:\SY\1.%20&#49892;&#54744;\CEBPb\0.2015_C%20EBPb%20&#45436;&#47928;%20&#44288;&#47144;\C%20EBP%20&#45436;&#47928;%20data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G:\SY\1.%20&#49892;&#54744;\CEBPb\2.%20293\1.%20promoter%20luciferase%20assay\150330_pGL-Axin1%20reporter%20assay_293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Y\Desktop\160919_ChIP_GAPDH%20realtime_3T3%20293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Y\Desktop\160919_ChIP_GAPDH%20realtime_3T3%20293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SY\Desktop\160919_ChIP_GAPDH%20realtime_3T3%2029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Sheet1!$F$60,Sheet1!$F$61)</c:f>
                <c:numCache>
                  <c:formatCode>General</c:formatCode>
                  <c:ptCount val="2"/>
                  <c:pt idx="0">
                    <c:v>0.12386025275185716</c:v>
                  </c:pt>
                  <c:pt idx="1">
                    <c:v>7.702638074646781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Sheet1!$E$60,Sheet1!$E$61)</c:f>
              <c:numCache>
                <c:formatCode>0.000_ </c:formatCode>
                <c:ptCount val="2"/>
                <c:pt idx="0">
                  <c:v>1</c:v>
                </c:pt>
                <c:pt idx="1">
                  <c:v>0.7015461735668036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64738816"/>
        <c:axId val="89709312"/>
      </c:barChart>
      <c:catAx>
        <c:axId val="64738816"/>
        <c:scaling>
          <c:orientation val="minMax"/>
        </c:scaling>
        <c:delete val="0"/>
        <c:axPos val="b"/>
        <c:majorTickMark val="in"/>
        <c:minorTickMark val="none"/>
        <c:tickLblPos val="none"/>
        <c:spPr>
          <a:ln w="9525">
            <a:solidFill>
              <a:sysClr val="windowText" lastClr="000000"/>
            </a:solidFill>
          </a:ln>
        </c:spPr>
        <c:crossAx val="89709312"/>
        <c:crosses val="autoZero"/>
        <c:auto val="1"/>
        <c:lblAlgn val="ctr"/>
        <c:lblOffset val="100"/>
        <c:noMultiLvlLbl val="0"/>
      </c:catAx>
      <c:valAx>
        <c:axId val="89709312"/>
        <c:scaling>
          <c:orientation val="minMax"/>
          <c:min val="0"/>
        </c:scaling>
        <c:delete val="0"/>
        <c:axPos val="l"/>
        <c:numFmt formatCode="0.000_ " sourceLinked="1"/>
        <c:majorTickMark val="in"/>
        <c:minorTickMark val="none"/>
        <c:tickLblPos val="none"/>
        <c:spPr>
          <a:ln w="9525">
            <a:solidFill>
              <a:schemeClr val="tx1"/>
            </a:solidFill>
          </a:ln>
        </c:spPr>
        <c:crossAx val="64738816"/>
        <c:crosses val="autoZero"/>
        <c:crossBetween val="between"/>
        <c:majorUnit val="0.25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6674475815428504E-2"/>
          <c:y val="3.3151611094091905E-2"/>
          <c:w val="0.9232196491561655"/>
          <c:h val="0.8972992330645797"/>
        </c:manualLayout>
      </c:layout>
      <c:barChart>
        <c:barDir val="col"/>
        <c:grouping val="clustered"/>
        <c:varyColors val="0"/>
        <c:ser>
          <c:idx val="0"/>
          <c:order val="0"/>
          <c:tx>
            <c:v>no MDI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3T3-L1 RT ChIP'!$E$3,'3T3-L1 RT ChIP'!$G$3,'3T3-L1 RT ChIP'!$I$3,'3T3-L1 RT ChIP'!$K$3)</c:f>
                <c:numCache>
                  <c:formatCode>General</c:formatCode>
                  <c:ptCount val="4"/>
                  <c:pt idx="0">
                    <c:v>1.1963766982777249E-2</c:v>
                  </c:pt>
                  <c:pt idx="1">
                    <c:v>4.0189986707701804E-2</c:v>
                  </c:pt>
                  <c:pt idx="2">
                    <c:v>0.24554699170988167</c:v>
                  </c:pt>
                  <c:pt idx="3">
                    <c:v>0.1332979269822409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D:\SY\1. 실험\CEBPb\0.2015_C EBPb 논문 관련\3.3T3-L1\1. Realtime PCR\1.Wnt component\[131125_3T3-L1 MDI_Wnt components.xlsx]Sheet1'!$B$41,'D:\SY\1. 실험\CEBPb\0.2015_C EBPb 논문 관련\3.3T3-L1\1. Realtime PCR\1.Wnt component\[131125_3T3-L1 MDI_Wnt components.xlsx]Sheet1'!$D$41,'D:\SY\1. 실험\CEBPb\0.2015_C EBPb 논문 관련\3.3T3-L1\1. Realtime PCR\1.Wnt component\[131125_3T3-L1 MDI_Wnt components.xlsx]Sheet1'!$F$41,'D:\SY\1. 실험\CEBPb\0.2015_C EBPb 논문 관련\3.3T3-L1\1. Realtime PCR\1.Wnt component\[131125_3T3-L1 MDI_Wnt components.xlsx]Sheet1'!$H$41,'D:\SY\1. 실험\CEBPb\0.2015_C EBPb 논문 관련\3.3T3-L1\1. Realtime PCR\1.Wnt component\[131125_3T3-L1 MDI_Wnt components.xlsx]Sheet1'!$J$41,'D:\SY\1. 실험\CEBPb\0.2015_C EBPb 논문 관련\3.3T3-L1\1. Realtime PCR\1.Wnt component\[131125_3T3-L1 MDI_Wnt components.xlsx]Sheet1'!$L$41)</c:f>
              <c:strCache>
                <c:ptCount val="6"/>
                <c:pt idx="0">
                  <c:v>Axin1</c:v>
                </c:pt>
                <c:pt idx="1">
                  <c:v>GSK-3β</c:v>
                </c:pt>
                <c:pt idx="2">
                  <c:v>β-TrCP</c:v>
                </c:pt>
                <c:pt idx="3">
                  <c:v>APC</c:v>
                </c:pt>
                <c:pt idx="4">
                  <c:v>β-ca</c:v>
                </c:pt>
                <c:pt idx="5">
                  <c:v>con</c:v>
                </c:pt>
              </c:strCache>
            </c:strRef>
          </c:cat>
          <c:val>
            <c:numRef>
              <c:f>('3T3-L1 RT ChIP'!$D$3,'3T3-L1 RT ChIP'!$F$3,'3T3-L1 RT ChIP'!$H$3)</c:f>
              <c:numCache>
                <c:formatCode>General</c:formatCode>
                <c:ptCount val="3"/>
                <c:pt idx="0">
                  <c:v>1</c:v>
                </c:pt>
                <c:pt idx="1">
                  <c:v>1</c:v>
                </c:pt>
                <c:pt idx="2">
                  <c:v>1</c:v>
                </c:pt>
              </c:numCache>
            </c:numRef>
          </c:val>
        </c:ser>
        <c:ser>
          <c:idx val="1"/>
          <c:order val="1"/>
          <c:tx>
            <c:v>MDI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3T3-L1 RT ChIP'!$E$4,'3T3-L1 RT ChIP'!$G$4,'3T3-L1 RT ChIP'!$I$4,'3T3-L1 RT ChIP'!$K$4)</c:f>
                <c:numCache>
                  <c:formatCode>General</c:formatCode>
                  <c:ptCount val="4"/>
                  <c:pt idx="0">
                    <c:v>3.0826317519398436E-2</c:v>
                  </c:pt>
                  <c:pt idx="1">
                    <c:v>5.4996181225075873E-2</c:v>
                  </c:pt>
                  <c:pt idx="2">
                    <c:v>0.29071524448600294</c:v>
                  </c:pt>
                  <c:pt idx="3">
                    <c:v>2.2284700102377229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'D:\SY\1. 실험\CEBPb\0.2015_C EBPb 논문 관련\3.3T3-L1\1. Realtime PCR\1.Wnt component\[131125_3T3-L1 MDI_Wnt components.xlsx]Sheet1'!$B$41,'D:\SY\1. 실험\CEBPb\0.2015_C EBPb 논문 관련\3.3T3-L1\1. Realtime PCR\1.Wnt component\[131125_3T3-L1 MDI_Wnt components.xlsx]Sheet1'!$D$41,'D:\SY\1. 실험\CEBPb\0.2015_C EBPb 논문 관련\3.3T3-L1\1. Realtime PCR\1.Wnt component\[131125_3T3-L1 MDI_Wnt components.xlsx]Sheet1'!$F$41,'D:\SY\1. 실험\CEBPb\0.2015_C EBPb 논문 관련\3.3T3-L1\1. Realtime PCR\1.Wnt component\[131125_3T3-L1 MDI_Wnt components.xlsx]Sheet1'!$H$41,'D:\SY\1. 실험\CEBPb\0.2015_C EBPb 논문 관련\3.3T3-L1\1. Realtime PCR\1.Wnt component\[131125_3T3-L1 MDI_Wnt components.xlsx]Sheet1'!$J$41,'D:\SY\1. 실험\CEBPb\0.2015_C EBPb 논문 관련\3.3T3-L1\1. Realtime PCR\1.Wnt component\[131125_3T3-L1 MDI_Wnt components.xlsx]Sheet1'!$L$41)</c:f>
              <c:strCache>
                <c:ptCount val="6"/>
                <c:pt idx="0">
                  <c:v>Axin1</c:v>
                </c:pt>
                <c:pt idx="1">
                  <c:v>GSK-3β</c:v>
                </c:pt>
                <c:pt idx="2">
                  <c:v>β-TrCP</c:v>
                </c:pt>
                <c:pt idx="3">
                  <c:v>APC</c:v>
                </c:pt>
                <c:pt idx="4">
                  <c:v>β-ca</c:v>
                </c:pt>
                <c:pt idx="5">
                  <c:v>con</c:v>
                </c:pt>
              </c:strCache>
            </c:strRef>
          </c:cat>
          <c:val>
            <c:numRef>
              <c:f>('3T3-L1 RT ChIP'!$D$4,'3T3-L1 RT ChIP'!$F$4,'3T3-L1 RT ChIP'!$H$4)</c:f>
              <c:numCache>
                <c:formatCode>0.000_ </c:formatCode>
                <c:ptCount val="3"/>
                <c:pt idx="0">
                  <c:v>1.3757043918703278</c:v>
                </c:pt>
                <c:pt idx="1">
                  <c:v>1.0333022478400911</c:v>
                </c:pt>
                <c:pt idx="2">
                  <c:v>1.52406832325110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89778176"/>
        <c:axId val="65631296"/>
      </c:barChart>
      <c:catAx>
        <c:axId val="89778176"/>
        <c:scaling>
          <c:orientation val="minMax"/>
        </c:scaling>
        <c:delete val="0"/>
        <c:axPos val="b"/>
        <c:numFmt formatCode="General" sourceLinked="0"/>
        <c:majorTickMark val="in"/>
        <c:minorTickMark val="none"/>
        <c:tickLblPos val="none"/>
        <c:spPr>
          <a:ln>
            <a:solidFill>
              <a:schemeClr val="tx1"/>
            </a:solidFill>
          </a:ln>
        </c:spPr>
        <c:crossAx val="65631296"/>
        <c:crosses val="autoZero"/>
        <c:auto val="1"/>
        <c:lblAlgn val="ctr"/>
        <c:lblOffset val="100"/>
        <c:noMultiLvlLbl val="0"/>
      </c:catAx>
      <c:valAx>
        <c:axId val="65631296"/>
        <c:scaling>
          <c:orientation val="minMax"/>
        </c:scaling>
        <c:delete val="0"/>
        <c:axPos val="l"/>
        <c:numFmt formatCode="General" sourceLinked="1"/>
        <c:majorTickMark val="in"/>
        <c:minorTickMark val="none"/>
        <c:tickLblPos val="none"/>
        <c:spPr>
          <a:ln>
            <a:solidFill>
              <a:sysClr val="windowText" lastClr="000000"/>
            </a:solidFill>
          </a:ln>
        </c:spPr>
        <c:crossAx val="89778176"/>
        <c:crosses val="autoZero"/>
        <c:crossBetween val="between"/>
        <c:majorUnit val="0.5"/>
      </c:valAx>
    </c:plotArea>
    <c:plotVisOnly val="1"/>
    <c:dispBlanksAs val="gap"/>
    <c:showDLblsOverMax val="0"/>
  </c:chart>
  <c:txPr>
    <a:bodyPr/>
    <a:lstStyle/>
    <a:p>
      <a:pPr>
        <a:defRPr sz="800"/>
      </a:pPr>
      <a:endParaRPr lang="ko-KR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bar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Sheet3!$H$24:$K$24</c:f>
                <c:numCache>
                  <c:formatCode>General</c:formatCode>
                  <c:ptCount val="4"/>
                  <c:pt idx="0">
                    <c:v>0.21964185503295899</c:v>
                  </c:pt>
                  <c:pt idx="1">
                    <c:v>1.3310496126485898</c:v>
                  </c:pt>
                  <c:pt idx="2">
                    <c:v>1.11515668681361</c:v>
                  </c:pt>
                  <c:pt idx="3">
                    <c:v>0.5784467446046740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strRef>
              <c:f>(Sheet3!$B$26,Sheet3!$C$26,Sheet3!$E$26,Sheet3!$G$26)</c:f>
              <c:strCache>
                <c:ptCount val="4"/>
                <c:pt idx="0">
                  <c:v>pcDNA</c:v>
                </c:pt>
                <c:pt idx="1">
                  <c:v>C/EBPβ</c:v>
                </c:pt>
                <c:pt idx="2">
                  <c:v>C/EBPα</c:v>
                </c:pt>
                <c:pt idx="3">
                  <c:v>LIP</c:v>
                </c:pt>
              </c:strCache>
            </c:strRef>
          </c:cat>
          <c:val>
            <c:numRef>
              <c:f>(Sheet3!$B$23,Sheet3!$C$23,Sheet3!$E$23,Sheet3!$G$23)</c:f>
              <c:numCache>
                <c:formatCode>#0.000</c:formatCode>
                <c:ptCount val="4"/>
                <c:pt idx="0">
                  <c:v>1</c:v>
                </c:pt>
                <c:pt idx="1">
                  <c:v>35.933657678672112</c:v>
                </c:pt>
                <c:pt idx="2">
                  <c:v>6.3414198102573485</c:v>
                </c:pt>
                <c:pt idx="3">
                  <c:v>4.14858893827764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6752000"/>
        <c:axId val="147136512"/>
      </c:barChart>
      <c:catAx>
        <c:axId val="146752000"/>
        <c:scaling>
          <c:orientation val="maxMin"/>
        </c:scaling>
        <c:delete val="0"/>
        <c:axPos val="l"/>
        <c:numFmt formatCode="General" sourceLinked="0"/>
        <c:majorTickMark val="in"/>
        <c:minorTickMark val="none"/>
        <c:tickLblPos val="none"/>
        <c:spPr>
          <a:ln w="9525">
            <a:solidFill>
              <a:schemeClr val="tx1"/>
            </a:solidFill>
          </a:ln>
        </c:spPr>
        <c:crossAx val="147136512"/>
        <c:crosses val="autoZero"/>
        <c:auto val="1"/>
        <c:lblAlgn val="ctr"/>
        <c:lblOffset val="100"/>
        <c:noMultiLvlLbl val="0"/>
      </c:catAx>
      <c:valAx>
        <c:axId val="147136512"/>
        <c:scaling>
          <c:orientation val="minMax"/>
        </c:scaling>
        <c:delete val="0"/>
        <c:axPos val="t"/>
        <c:numFmt formatCode="General" sourceLinked="0"/>
        <c:majorTickMark val="in"/>
        <c:minorTickMark val="none"/>
        <c:tickLblPos val="none"/>
        <c:spPr>
          <a:ln w="9525">
            <a:solidFill>
              <a:sysClr val="windowText" lastClr="000000"/>
            </a:solidFill>
          </a:ln>
        </c:spPr>
        <c:crossAx val="146752000"/>
        <c:crosses val="autoZero"/>
        <c:crossBetween val="between"/>
        <c:majorUnit val="10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9863945578231416E-2"/>
          <c:y val="7.0512784921873392E-2"/>
          <c:w val="0.88038352348813531"/>
          <c:h val="0.85897443015625374"/>
        </c:manualLayout>
      </c:layout>
      <c:barChart>
        <c:barDir val="col"/>
        <c:grouping val="clustered"/>
        <c:varyColors val="0"/>
        <c:ser>
          <c:idx val="0"/>
          <c:order val="0"/>
          <c:tx>
            <c:v>IgG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293'!$S$20,'293'!$V$20)</c:f>
                <c:numCache>
                  <c:formatCode>General</c:formatCode>
                  <c:ptCount val="2"/>
                  <c:pt idx="0">
                    <c:v>0.40045861857673865</c:v>
                  </c:pt>
                  <c:pt idx="1">
                    <c:v>0.289910784230820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'293'!$S$19,'293'!$V$19)</c:f>
              <c:numCache>
                <c:formatCode>0.0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v>C/EBPβ</c:v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293'!$T$20,'293'!$W$20)</c:f>
                <c:numCache>
                  <c:formatCode>General</c:formatCode>
                  <c:ptCount val="2"/>
                  <c:pt idx="0">
                    <c:v>3.5501341965722688E-3</c:v>
                  </c:pt>
                  <c:pt idx="1">
                    <c:v>0.16561405384866326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'293'!$T$19,'293'!$W$19)</c:f>
              <c:numCache>
                <c:formatCode>0.000</c:formatCode>
                <c:ptCount val="2"/>
                <c:pt idx="0">
                  <c:v>0.72432928696486965</c:v>
                </c:pt>
                <c:pt idx="1">
                  <c:v>1.130385219451556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550208"/>
        <c:axId val="147138240"/>
      </c:barChart>
      <c:catAx>
        <c:axId val="147550208"/>
        <c:scaling>
          <c:orientation val="minMax"/>
        </c:scaling>
        <c:delete val="0"/>
        <c:axPos val="b"/>
        <c:majorTickMark val="in"/>
        <c:minorTickMark val="none"/>
        <c:tickLblPos val="none"/>
        <c:spPr>
          <a:noFill/>
          <a:ln>
            <a:solidFill>
              <a:prstClr val="black"/>
            </a:solidFill>
          </a:ln>
        </c:spPr>
        <c:crossAx val="147138240"/>
        <c:crosses val="autoZero"/>
        <c:auto val="1"/>
        <c:lblAlgn val="ctr"/>
        <c:lblOffset val="100"/>
        <c:noMultiLvlLbl val="0"/>
      </c:catAx>
      <c:valAx>
        <c:axId val="147138240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one"/>
        <c:spPr>
          <a:ln>
            <a:solidFill>
              <a:prstClr val="black"/>
            </a:solidFill>
          </a:ln>
        </c:spPr>
        <c:crossAx val="1475502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9863945578231416E-2"/>
          <c:y val="7.0512784921873392E-2"/>
          <c:w val="0.88038352348813531"/>
          <c:h val="0.85897443015625374"/>
        </c:manualLayout>
      </c:layout>
      <c:barChart>
        <c:barDir val="col"/>
        <c:grouping val="clustered"/>
        <c:varyColors val="0"/>
        <c:ser>
          <c:idx val="0"/>
          <c:order val="0"/>
          <c:tx>
            <c:v>IgG</c:v>
          </c:tx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('3T3-L1'!$K$20,'3T3-L1'!$N$20)</c:f>
                <c:numCache>
                  <c:formatCode>General</c:formatCode>
                  <c:ptCount val="2"/>
                  <c:pt idx="0">
                    <c:v>0.15135809028482392</c:v>
                  </c:pt>
                  <c:pt idx="1">
                    <c:v>9.2990157949496208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'3T3-L1'!$K$19,'3T3-L1'!$N$19)</c:f>
              <c:numCache>
                <c:formatCode>0.0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v>C/EBPβ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3T3-L1'!$L$20,'3T3-L1'!$O$20)</c:f>
                <c:numCache>
                  <c:formatCode>General</c:formatCode>
                  <c:ptCount val="2"/>
                  <c:pt idx="0">
                    <c:v>0.14831781157464274</c:v>
                  </c:pt>
                  <c:pt idx="1">
                    <c:v>0.2691823137851893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'3T3-L1'!$L$19,'3T3-L1'!$O$19)</c:f>
              <c:numCache>
                <c:formatCode>0.000</c:formatCode>
                <c:ptCount val="2"/>
                <c:pt idx="0">
                  <c:v>0.6779092959937828</c:v>
                </c:pt>
                <c:pt idx="1">
                  <c:v>1.348532634907368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550720"/>
        <c:axId val="147139968"/>
      </c:barChart>
      <c:catAx>
        <c:axId val="147550720"/>
        <c:scaling>
          <c:orientation val="minMax"/>
        </c:scaling>
        <c:delete val="0"/>
        <c:axPos val="b"/>
        <c:majorTickMark val="in"/>
        <c:minorTickMark val="none"/>
        <c:tickLblPos val="none"/>
        <c:spPr>
          <a:noFill/>
          <a:ln>
            <a:solidFill>
              <a:prstClr val="black"/>
            </a:solidFill>
          </a:ln>
        </c:spPr>
        <c:crossAx val="147139968"/>
        <c:crosses val="autoZero"/>
        <c:auto val="1"/>
        <c:lblAlgn val="ctr"/>
        <c:lblOffset val="100"/>
        <c:noMultiLvlLbl val="0"/>
      </c:catAx>
      <c:valAx>
        <c:axId val="147139968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one"/>
        <c:spPr>
          <a:ln>
            <a:solidFill>
              <a:prstClr val="black"/>
            </a:solidFill>
          </a:ln>
        </c:spPr>
        <c:crossAx val="1475507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5.9863945578231416E-2"/>
          <c:y val="7.0512784921873392E-2"/>
          <c:w val="0.88038352348813531"/>
          <c:h val="0.85897443015625374"/>
        </c:manualLayout>
      </c:layout>
      <c:barChart>
        <c:barDir val="col"/>
        <c:grouping val="clustered"/>
        <c:varyColors val="0"/>
        <c:ser>
          <c:idx val="0"/>
          <c:order val="0"/>
          <c:tx>
            <c:v>IgG</c:v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('293'!$AC$20,'293'!$AF$20)</c:f>
                <c:numCache>
                  <c:formatCode>General</c:formatCode>
                  <c:ptCount val="2"/>
                  <c:pt idx="0">
                    <c:v>6.3673701109361186E-2</c:v>
                  </c:pt>
                  <c:pt idx="1">
                    <c:v>6.3673701109362837E-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'293'!$AC$19,'293'!$AF$19)</c:f>
              <c:numCache>
                <c:formatCode>0.000</c:formatCode>
                <c:ptCount val="2"/>
                <c:pt idx="0">
                  <c:v>1</c:v>
                </c:pt>
                <c:pt idx="1">
                  <c:v>1</c:v>
                </c:pt>
              </c:numCache>
            </c:numRef>
          </c:val>
        </c:ser>
        <c:ser>
          <c:idx val="1"/>
          <c:order val="1"/>
          <c:tx>
            <c:v>C/EBPβ</c:v>
          </c:tx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('293'!$AD$20,'293'!$AG$20)</c:f>
                <c:numCache>
                  <c:formatCode>General</c:formatCode>
                  <c:ptCount val="2"/>
                  <c:pt idx="0">
                    <c:v>0.23298634669241181</c:v>
                  </c:pt>
                  <c:pt idx="1">
                    <c:v>0.1756777154393486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('293'!$AD$19,'293'!$AG$19)</c:f>
              <c:numCache>
                <c:formatCode>0.000</c:formatCode>
                <c:ptCount val="2"/>
                <c:pt idx="0">
                  <c:v>1.1672003542301344</c:v>
                </c:pt>
                <c:pt idx="1">
                  <c:v>1.561697262434335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47551744"/>
        <c:axId val="147141696"/>
      </c:barChart>
      <c:catAx>
        <c:axId val="147551744"/>
        <c:scaling>
          <c:orientation val="minMax"/>
        </c:scaling>
        <c:delete val="0"/>
        <c:axPos val="b"/>
        <c:majorTickMark val="in"/>
        <c:minorTickMark val="none"/>
        <c:tickLblPos val="none"/>
        <c:spPr>
          <a:noFill/>
          <a:ln>
            <a:solidFill>
              <a:prstClr val="black"/>
            </a:solidFill>
          </a:ln>
        </c:spPr>
        <c:crossAx val="147141696"/>
        <c:crosses val="autoZero"/>
        <c:auto val="1"/>
        <c:lblAlgn val="ctr"/>
        <c:lblOffset val="100"/>
        <c:noMultiLvlLbl val="0"/>
      </c:catAx>
      <c:valAx>
        <c:axId val="147141696"/>
        <c:scaling>
          <c:orientation val="minMax"/>
        </c:scaling>
        <c:delete val="0"/>
        <c:axPos val="l"/>
        <c:numFmt formatCode="General" sourceLinked="0"/>
        <c:majorTickMark val="in"/>
        <c:minorTickMark val="none"/>
        <c:tickLblPos val="none"/>
        <c:spPr>
          <a:ln>
            <a:solidFill>
              <a:prstClr val="black"/>
            </a:solidFill>
          </a:ln>
        </c:spPr>
        <c:crossAx val="14755174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30916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97680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583807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0484673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695591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2186768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974761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373836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728333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119843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9778149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3308BB-3BDA-45B2-AFCC-90B52B8D9833}" type="datetimeFigureOut">
              <a:rPr lang="ko-KR" altLang="en-US" smtClean="0"/>
              <a:pPr/>
              <a:t>2018-09-10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713DE1A-9081-42DF-9606-26EE6BA5EF81}" type="slidenum">
              <a:rPr lang="ko-KR" altLang="en-US" smtClean="0"/>
              <a:pPr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737005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6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12.png"/><Relationship Id="rId5" Type="http://schemas.openxmlformats.org/officeDocument/2006/relationships/image" Target="../media/image11.png"/><Relationship Id="rId4" Type="http://schemas.openxmlformats.org/officeDocument/2006/relationships/image" Target="../media/image10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8" name="그룹 27"/>
          <p:cNvGrpSpPr/>
          <p:nvPr/>
        </p:nvGrpSpPr>
        <p:grpSpPr>
          <a:xfrm>
            <a:off x="3647132" y="1567181"/>
            <a:ext cx="2051868" cy="2708276"/>
            <a:chOff x="3853632" y="2074334"/>
            <a:chExt cx="2089972" cy="2355030"/>
          </a:xfrm>
        </p:grpSpPr>
        <p:grpSp>
          <p:nvGrpSpPr>
            <p:cNvPr id="25" name="그룹 24"/>
            <p:cNvGrpSpPr/>
            <p:nvPr/>
          </p:nvGrpSpPr>
          <p:grpSpPr>
            <a:xfrm>
              <a:off x="3853632" y="2074334"/>
              <a:ext cx="2089972" cy="2249598"/>
              <a:chOff x="4371081" y="2748824"/>
              <a:chExt cx="1395486" cy="1575107"/>
            </a:xfrm>
          </p:grpSpPr>
          <p:sp>
            <p:nvSpPr>
              <p:cNvPr id="5" name="TextBox 142"/>
              <p:cNvSpPr txBox="1"/>
              <p:nvPr/>
            </p:nvSpPr>
            <p:spPr>
              <a:xfrm rot="16200000">
                <a:off x="3665729" y="3454176"/>
                <a:ext cx="1575107" cy="16440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altLang="ko-KR" sz="10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Relative  Axin2 mRNA  levels</a:t>
                </a:r>
                <a:endParaRPr lang="ko-KR" altLang="en-US" sz="10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6" name="TextBox 144"/>
              <p:cNvSpPr txBox="1"/>
              <p:nvPr/>
            </p:nvSpPr>
            <p:spPr>
              <a:xfrm>
                <a:off x="4571387" y="4084891"/>
                <a:ext cx="161835" cy="150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0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7" name="TextBox 145"/>
              <p:cNvSpPr txBox="1"/>
              <p:nvPr/>
            </p:nvSpPr>
            <p:spPr>
              <a:xfrm>
                <a:off x="4518971" y="3831315"/>
                <a:ext cx="200367" cy="150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25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8" name="TextBox 146"/>
              <p:cNvSpPr txBox="1"/>
              <p:nvPr/>
            </p:nvSpPr>
            <p:spPr>
              <a:xfrm>
                <a:off x="4516660" y="3323108"/>
                <a:ext cx="200367" cy="150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75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9" name="TextBox 147"/>
              <p:cNvSpPr txBox="1"/>
              <p:nvPr/>
            </p:nvSpPr>
            <p:spPr>
              <a:xfrm>
                <a:off x="4466556" y="2816542"/>
                <a:ext cx="238898" cy="150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125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graphicFrame>
            <p:nvGraphicFramePr>
              <p:cNvPr id="10" name="차트 9"/>
              <p:cNvGraphicFramePr>
                <a:graphicFrameLocks/>
              </p:cNvGraphicFramePr>
              <p:nvPr/>
            </p:nvGraphicFramePr>
            <p:xfrm>
              <a:off x="4611285" y="2775931"/>
              <a:ext cx="1155282" cy="1548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1" name="TextBox 170"/>
              <p:cNvSpPr txBox="1"/>
              <p:nvPr/>
            </p:nvSpPr>
            <p:spPr>
              <a:xfrm>
                <a:off x="5350615" y="3239358"/>
                <a:ext cx="156483" cy="17239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10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*</a:t>
                </a:r>
                <a:endParaRPr lang="ko-KR" altLang="en-US" sz="10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2" name="TextBox 145"/>
              <p:cNvSpPr txBox="1"/>
              <p:nvPr/>
            </p:nvSpPr>
            <p:spPr>
              <a:xfrm>
                <a:off x="4518976" y="3586047"/>
                <a:ext cx="200367" cy="150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50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3" name="TextBox 147"/>
              <p:cNvSpPr txBox="1"/>
              <p:nvPr/>
            </p:nvSpPr>
            <p:spPr>
              <a:xfrm>
                <a:off x="4466561" y="3073714"/>
                <a:ext cx="238898" cy="150848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100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sp>
          <p:nvSpPr>
            <p:cNvPr id="26" name="TextBox 148"/>
            <p:cNvSpPr txBox="1"/>
            <p:nvPr/>
          </p:nvSpPr>
          <p:spPr>
            <a:xfrm>
              <a:off x="4440729" y="4183143"/>
              <a:ext cx="620683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No MDI</a:t>
              </a:r>
              <a:endParaRPr lang="ko-KR" altLang="en-US" sz="10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27" name="TextBox 149"/>
            <p:cNvSpPr txBox="1"/>
            <p:nvPr/>
          </p:nvSpPr>
          <p:spPr>
            <a:xfrm>
              <a:off x="5244345" y="4183142"/>
              <a:ext cx="42030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10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MDI</a:t>
              </a:r>
              <a:endParaRPr lang="ko-KR" altLang="en-US" sz="10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sp>
        <p:nvSpPr>
          <p:cNvPr id="16" name="직사각형 15"/>
          <p:cNvSpPr/>
          <p:nvPr/>
        </p:nvSpPr>
        <p:spPr>
          <a:xfrm>
            <a:off x="1183041" y="4750826"/>
            <a:ext cx="7894490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DI represses </a:t>
            </a:r>
            <a:r>
              <a:rPr lang="en-US" altLang="ko-KR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XIN2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expression; 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fter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cubation of 3T3-L1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cells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MDI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for 24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h,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otal RNA was subjected to real-time PCR for expression of </a:t>
            </a:r>
            <a:r>
              <a:rPr lang="en-US" altLang="ko-KR" sz="1200" i="1" dirty="0" smtClean="0">
                <a:latin typeface="Times New Roman" pitchFamily="18" charset="0"/>
                <a:cs typeface="Times New Roman" pitchFamily="18" charset="0"/>
              </a:rPr>
              <a:t>AXIN2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gene</a:t>
            </a:r>
            <a:endParaRPr lang="ko-KR" altLang="ko-K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95028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/>
          <p:cNvSpPr/>
          <p:nvPr/>
        </p:nvSpPr>
        <p:spPr>
          <a:xfrm>
            <a:off x="1097110" y="4769876"/>
            <a:ext cx="789449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DI does not alter the mRNA and protein levels of other factors in the destruction complex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. 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a, b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, After incubation of 3T3-L1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cells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with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MDI for 24 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h, </a:t>
            </a:r>
            <a:r>
              <a:rPr lang="en-US" altLang="ko-KR" sz="1200" dirty="0">
                <a:latin typeface="Times New Roman" pitchFamily="18" charset="0"/>
                <a:cs typeface="Times New Roman" pitchFamily="18" charset="0"/>
              </a:rPr>
              <a:t>t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otal RNA was subjected to real-time PCR for expression of the destruction complex components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, and whole cell lysates were subjected to western blot analysis using the indicated antibodies (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.</a:t>
            </a:r>
            <a:endParaRPr lang="ko-KR" altLang="ko-KR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2417972" y="1822632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a</a:t>
            </a:r>
            <a:endParaRPr lang="ko-KR" altLang="en-US" sz="1400" b="1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grpSp>
        <p:nvGrpSpPr>
          <p:cNvPr id="4" name="그룹 3"/>
          <p:cNvGrpSpPr/>
          <p:nvPr/>
        </p:nvGrpSpPr>
        <p:grpSpPr>
          <a:xfrm>
            <a:off x="5515538" y="1922604"/>
            <a:ext cx="1821634" cy="2291803"/>
            <a:chOff x="5198638" y="1817672"/>
            <a:chExt cx="1821634" cy="2291803"/>
          </a:xfrm>
        </p:grpSpPr>
        <p:grpSp>
          <p:nvGrpSpPr>
            <p:cNvPr id="5" name="그룹 78"/>
            <p:cNvGrpSpPr/>
            <p:nvPr/>
          </p:nvGrpSpPr>
          <p:grpSpPr>
            <a:xfrm>
              <a:off x="5534972" y="2650005"/>
              <a:ext cx="649789" cy="255215"/>
              <a:chOff x="4124264" y="3487640"/>
              <a:chExt cx="649789" cy="255215"/>
            </a:xfrm>
          </p:grpSpPr>
          <p:pic>
            <p:nvPicPr>
              <p:cNvPr id="34" name="Picture 9"/>
              <p:cNvPicPr preferRelativeResize="0">
                <a:picLocks noChangeArrowheads="1"/>
              </p:cNvPicPr>
              <p:nvPr/>
            </p:nvPicPr>
            <p:blipFill>
              <a:blip r:embed="rId2" cstate="print"/>
              <a:srcRect l="6061" r="3030"/>
              <a:stretch>
                <a:fillRect/>
              </a:stretch>
            </p:blipFill>
            <p:spPr bwMode="auto">
              <a:xfrm>
                <a:off x="4124264" y="3490855"/>
                <a:ext cx="648000" cy="25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5" name="직사각형 34"/>
              <p:cNvSpPr/>
              <p:nvPr/>
            </p:nvSpPr>
            <p:spPr>
              <a:xfrm>
                <a:off x="4126053" y="3487640"/>
                <a:ext cx="648000" cy="252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70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pSp>
          <p:nvGrpSpPr>
            <p:cNvPr id="6" name="그룹 77"/>
            <p:cNvGrpSpPr/>
            <p:nvPr/>
          </p:nvGrpSpPr>
          <p:grpSpPr>
            <a:xfrm>
              <a:off x="5534639" y="2946335"/>
              <a:ext cx="651176" cy="252793"/>
              <a:chOff x="4128693" y="3800944"/>
              <a:chExt cx="651176" cy="252793"/>
            </a:xfrm>
          </p:grpSpPr>
          <p:pic>
            <p:nvPicPr>
              <p:cNvPr id="32" name="Picture 12"/>
              <p:cNvPicPr preferRelativeResize="0">
                <a:picLocks noChangeArrowheads="1"/>
              </p:cNvPicPr>
              <p:nvPr/>
            </p:nvPicPr>
            <p:blipFill>
              <a:blip r:embed="rId3" cstate="print"/>
              <a:srcRect l="6131" r="4542"/>
              <a:stretch>
                <a:fillRect/>
              </a:stretch>
            </p:blipFill>
            <p:spPr bwMode="auto">
              <a:xfrm>
                <a:off x="4128693" y="3801737"/>
                <a:ext cx="648000" cy="25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3" name="직사각형 32"/>
              <p:cNvSpPr/>
              <p:nvPr/>
            </p:nvSpPr>
            <p:spPr>
              <a:xfrm>
                <a:off x="4131869" y="3800944"/>
                <a:ext cx="648000" cy="252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70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pSp>
          <p:nvGrpSpPr>
            <p:cNvPr id="7" name="그룹 76"/>
            <p:cNvGrpSpPr/>
            <p:nvPr/>
          </p:nvGrpSpPr>
          <p:grpSpPr>
            <a:xfrm>
              <a:off x="5536965" y="3242736"/>
              <a:ext cx="648060" cy="252072"/>
              <a:chOff x="4135781" y="4106528"/>
              <a:chExt cx="648060" cy="252072"/>
            </a:xfrm>
          </p:grpSpPr>
          <p:pic>
            <p:nvPicPr>
              <p:cNvPr id="30" name="Picture 9"/>
              <p:cNvPicPr preferRelativeResize="0">
                <a:picLocks noChangeArrowheads="1"/>
              </p:cNvPicPr>
              <p:nvPr/>
            </p:nvPicPr>
            <p:blipFill>
              <a:blip r:embed="rId4" cstate="print"/>
              <a:srcRect/>
              <a:stretch>
                <a:fillRect/>
              </a:stretch>
            </p:blipFill>
            <p:spPr bwMode="auto">
              <a:xfrm>
                <a:off x="4135841" y="4106600"/>
                <a:ext cx="648000" cy="25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31" name="직사각형 30"/>
              <p:cNvSpPr/>
              <p:nvPr/>
            </p:nvSpPr>
            <p:spPr>
              <a:xfrm>
                <a:off x="4135781" y="4106528"/>
                <a:ext cx="648000" cy="252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70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pSp>
          <p:nvGrpSpPr>
            <p:cNvPr id="8" name="그룹 73"/>
            <p:cNvGrpSpPr/>
            <p:nvPr/>
          </p:nvGrpSpPr>
          <p:grpSpPr>
            <a:xfrm>
              <a:off x="5534900" y="3856853"/>
              <a:ext cx="650915" cy="252622"/>
              <a:chOff x="4128954" y="5117930"/>
              <a:chExt cx="650915" cy="252622"/>
            </a:xfrm>
          </p:grpSpPr>
          <p:pic>
            <p:nvPicPr>
              <p:cNvPr id="28" name="Picture 4"/>
              <p:cNvPicPr preferRelativeResize="0">
                <a:picLocks noChangeArrowheads="1"/>
              </p:cNvPicPr>
              <p:nvPr/>
            </p:nvPicPr>
            <p:blipFill>
              <a:blip r:embed="rId5" cstate="print"/>
              <a:srcRect/>
              <a:stretch>
                <a:fillRect/>
              </a:stretch>
            </p:blipFill>
            <p:spPr bwMode="auto">
              <a:xfrm>
                <a:off x="4128954" y="5117930"/>
                <a:ext cx="648000" cy="25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9" name="직사각형 28"/>
              <p:cNvSpPr/>
              <p:nvPr/>
            </p:nvSpPr>
            <p:spPr>
              <a:xfrm>
                <a:off x="4131869" y="5118552"/>
                <a:ext cx="648000" cy="252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70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sp>
          <p:nvSpPr>
            <p:cNvPr id="9" name="TextBox 8"/>
            <p:cNvSpPr txBox="1"/>
            <p:nvPr/>
          </p:nvSpPr>
          <p:spPr>
            <a:xfrm>
              <a:off x="6171963" y="2973752"/>
              <a:ext cx="848309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phospho-GSK3β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6171963" y="3887228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err="1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Actin</a:t>
              </a:r>
              <a:endParaRPr lang="ko-KR" altLang="en-US" sz="7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6171963" y="2088599"/>
              <a:ext cx="39305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APC 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172637" y="2679155"/>
              <a:ext cx="47481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GSK3β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6169227" y="3573744"/>
              <a:ext cx="44435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err="1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PKCα</a:t>
              </a:r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 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6171963" y="2383402"/>
              <a:ext cx="50045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β-</a:t>
              </a:r>
              <a:r>
                <a:rPr lang="en-US" altLang="ko-KR" sz="700" b="1" dirty="0" err="1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TrCP</a:t>
              </a:r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 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6172236" y="3272884"/>
              <a:ext cx="38343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CK1 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198638" y="1817831"/>
              <a:ext cx="34977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MDI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581861" y="1817672"/>
              <a:ext cx="215123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-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grpSp>
          <p:nvGrpSpPr>
            <p:cNvPr id="18" name="그룹 82"/>
            <p:cNvGrpSpPr/>
            <p:nvPr/>
          </p:nvGrpSpPr>
          <p:grpSpPr>
            <a:xfrm>
              <a:off x="5534298" y="3547062"/>
              <a:ext cx="653762" cy="254115"/>
              <a:chOff x="4131666" y="2516064"/>
              <a:chExt cx="653762" cy="254115"/>
            </a:xfrm>
          </p:grpSpPr>
          <p:pic>
            <p:nvPicPr>
              <p:cNvPr id="26" name="Picture 11"/>
              <p:cNvPicPr preferRelativeResize="0">
                <a:picLocks noChangeArrowheads="1"/>
              </p:cNvPicPr>
              <p:nvPr/>
            </p:nvPicPr>
            <p:blipFill>
              <a:blip r:embed="rId6" cstate="print"/>
              <a:srcRect l="2739" r="1801"/>
              <a:stretch>
                <a:fillRect/>
              </a:stretch>
            </p:blipFill>
            <p:spPr bwMode="auto">
              <a:xfrm>
                <a:off x="4137428" y="2518179"/>
                <a:ext cx="648000" cy="25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7" name="직사각형 26"/>
              <p:cNvSpPr/>
              <p:nvPr/>
            </p:nvSpPr>
            <p:spPr>
              <a:xfrm>
                <a:off x="4131666" y="2516064"/>
                <a:ext cx="648000" cy="252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70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pSp>
          <p:nvGrpSpPr>
            <p:cNvPr id="19" name="그룹 81"/>
            <p:cNvGrpSpPr/>
            <p:nvPr/>
          </p:nvGrpSpPr>
          <p:grpSpPr>
            <a:xfrm>
              <a:off x="5537815" y="2060848"/>
              <a:ext cx="648666" cy="262589"/>
              <a:chOff x="4131869" y="2827360"/>
              <a:chExt cx="648666" cy="262589"/>
            </a:xfrm>
          </p:grpSpPr>
          <p:pic>
            <p:nvPicPr>
              <p:cNvPr id="24" name="Picture 5"/>
              <p:cNvPicPr preferRelativeResize="0">
                <a:picLocks noChangeArrowheads="1"/>
              </p:cNvPicPr>
              <p:nvPr/>
            </p:nvPicPr>
            <p:blipFill>
              <a:blip r:embed="rId7" cstate="print"/>
              <a:srcRect/>
              <a:stretch>
                <a:fillRect/>
              </a:stretch>
            </p:blipFill>
            <p:spPr bwMode="auto">
              <a:xfrm>
                <a:off x="4132535" y="2837949"/>
                <a:ext cx="648000" cy="25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5" name="직사각형 24"/>
              <p:cNvSpPr/>
              <p:nvPr/>
            </p:nvSpPr>
            <p:spPr>
              <a:xfrm>
                <a:off x="4131869" y="2827360"/>
                <a:ext cx="648000" cy="252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70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pSp>
          <p:nvGrpSpPr>
            <p:cNvPr id="20" name="그룹 80"/>
            <p:cNvGrpSpPr/>
            <p:nvPr/>
          </p:nvGrpSpPr>
          <p:grpSpPr>
            <a:xfrm>
              <a:off x="5537611" y="2354830"/>
              <a:ext cx="651306" cy="253260"/>
              <a:chOff x="4122141" y="3147124"/>
              <a:chExt cx="651306" cy="253260"/>
            </a:xfrm>
          </p:grpSpPr>
          <p:pic>
            <p:nvPicPr>
              <p:cNvPr id="22" name="Picture 2"/>
              <p:cNvPicPr preferRelativeResize="0">
                <a:picLocks noChangeArrowheads="1"/>
              </p:cNvPicPr>
              <p:nvPr/>
            </p:nvPicPr>
            <p:blipFill>
              <a:blip r:embed="rId8" cstate="print"/>
              <a:srcRect l="3455" r="2105"/>
              <a:stretch>
                <a:fillRect/>
              </a:stretch>
            </p:blipFill>
            <p:spPr bwMode="auto">
              <a:xfrm>
                <a:off x="4125447" y="3147124"/>
                <a:ext cx="648000" cy="2520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23" name="직사각형 22"/>
              <p:cNvSpPr/>
              <p:nvPr/>
            </p:nvSpPr>
            <p:spPr>
              <a:xfrm>
                <a:off x="4122141" y="3148384"/>
                <a:ext cx="648000" cy="252000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70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sp>
          <p:nvSpPr>
            <p:cNvPr id="21" name="TextBox 20"/>
            <p:cNvSpPr txBox="1"/>
            <p:nvPr/>
          </p:nvSpPr>
          <p:spPr>
            <a:xfrm>
              <a:off x="5903557" y="1826056"/>
              <a:ext cx="23756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+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sp>
        <p:nvSpPr>
          <p:cNvPr id="36" name="TextBox 35"/>
          <p:cNvSpPr txBox="1"/>
          <p:nvPr/>
        </p:nvSpPr>
        <p:spPr>
          <a:xfrm>
            <a:off x="5317522" y="1708023"/>
            <a:ext cx="28405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400" b="1" dirty="0" smtClean="0">
                <a:latin typeface="Arial Unicode MS" pitchFamily="50" charset="-127"/>
                <a:ea typeface="Arial Unicode MS" pitchFamily="50" charset="-127"/>
                <a:cs typeface="Arial Unicode MS" pitchFamily="50" charset="-127"/>
              </a:rPr>
              <a:t>b</a:t>
            </a:r>
            <a:endParaRPr lang="ko-KR" altLang="en-US" sz="1400" b="1" dirty="0">
              <a:latin typeface="Arial Unicode MS" pitchFamily="50" charset="-127"/>
              <a:ea typeface="Arial Unicode MS" pitchFamily="50" charset="-127"/>
              <a:cs typeface="Arial Unicode MS" pitchFamily="50" charset="-127"/>
            </a:endParaRPr>
          </a:p>
        </p:txBody>
      </p:sp>
      <p:grpSp>
        <p:nvGrpSpPr>
          <p:cNvPr id="37" name="그룹 36"/>
          <p:cNvGrpSpPr/>
          <p:nvPr/>
        </p:nvGrpSpPr>
        <p:grpSpPr>
          <a:xfrm>
            <a:off x="2656628" y="2161588"/>
            <a:ext cx="1774700" cy="1790843"/>
            <a:chOff x="2251144" y="2071896"/>
            <a:chExt cx="1774700" cy="1790843"/>
          </a:xfrm>
        </p:grpSpPr>
        <p:sp>
          <p:nvSpPr>
            <p:cNvPr id="38" name="TextBox 37"/>
            <p:cNvSpPr txBox="1"/>
            <p:nvPr/>
          </p:nvSpPr>
          <p:spPr>
            <a:xfrm rot="16200000">
              <a:off x="1786747" y="2739570"/>
              <a:ext cx="1128849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Relative mRNA levels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2433876" y="3504174"/>
              <a:ext cx="2359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0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2358909" y="3148613"/>
              <a:ext cx="3097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0.5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2433067" y="2790013"/>
              <a:ext cx="2359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1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2359132" y="2430538"/>
              <a:ext cx="309700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1.5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2432943" y="2071896"/>
              <a:ext cx="235962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2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2651364" y="3601250"/>
              <a:ext cx="505267" cy="2586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GSK-3</a:t>
              </a:r>
              <a:r>
                <a:rPr lang="el-GR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β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3110166" y="3604068"/>
              <a:ext cx="474810" cy="2586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l-GR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β</a:t>
              </a:r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-</a:t>
              </a:r>
              <a:r>
                <a:rPr lang="en-US" altLang="ko-KR" sz="700" b="1" dirty="0" err="1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TrCP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46" name="TextBox 45"/>
            <p:cNvSpPr txBox="1"/>
            <p:nvPr/>
          </p:nvSpPr>
          <p:spPr>
            <a:xfrm>
              <a:off x="3611840" y="3601255"/>
              <a:ext cx="367408" cy="25867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APC</a:t>
              </a:r>
              <a:endParaRPr lang="ko-KR" altLang="en-US" sz="7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grpSp>
          <p:nvGrpSpPr>
            <p:cNvPr id="47" name="그룹 68"/>
            <p:cNvGrpSpPr/>
            <p:nvPr/>
          </p:nvGrpSpPr>
          <p:grpSpPr>
            <a:xfrm>
              <a:off x="2720858" y="2117682"/>
              <a:ext cx="402926" cy="258867"/>
              <a:chOff x="2800909" y="3979604"/>
              <a:chExt cx="402926" cy="283884"/>
            </a:xfrm>
          </p:grpSpPr>
          <p:sp>
            <p:nvSpPr>
              <p:cNvPr id="49" name="직사각형 48"/>
              <p:cNvSpPr/>
              <p:nvPr/>
            </p:nvSpPr>
            <p:spPr>
              <a:xfrm>
                <a:off x="2800909" y="4038545"/>
                <a:ext cx="72008" cy="72008"/>
              </a:xfrm>
              <a:prstGeom prst="rect">
                <a:avLst/>
              </a:prstGeom>
              <a:solidFill>
                <a:schemeClr val="bg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500"/>
              </a:p>
            </p:txBody>
          </p:sp>
          <p:sp>
            <p:nvSpPr>
              <p:cNvPr id="50" name="직사각형 49"/>
              <p:cNvSpPr/>
              <p:nvPr/>
            </p:nvSpPr>
            <p:spPr>
              <a:xfrm>
                <a:off x="2800909" y="4152845"/>
                <a:ext cx="72008" cy="72008"/>
              </a:xfrm>
              <a:prstGeom prst="rect">
                <a:avLst/>
              </a:prstGeom>
              <a:solidFill>
                <a:schemeClr val="tx1"/>
              </a:solidFill>
              <a:ln w="63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ko-KR" altLang="en-US" sz="500" dirty="0">
                  <a:solidFill>
                    <a:srgbClr val="FF0000"/>
                  </a:solidFill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2802763" y="3979604"/>
                <a:ext cx="401072" cy="1692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 MDI</a:t>
                </a:r>
                <a:endParaRPr lang="ko-KR" altLang="en-US" sz="5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2804033" y="4094212"/>
                <a:ext cx="301686" cy="16927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5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MDI</a:t>
                </a:r>
                <a:endParaRPr lang="ko-KR" altLang="en-US" sz="5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aphicFrame>
          <p:nvGraphicFramePr>
            <p:cNvPr id="48" name="차트 47"/>
            <p:cNvGraphicFramePr/>
            <p:nvPr>
              <p:extLst>
                <p:ext uri="{D42A27DB-BD31-4B8C-83A1-F6EECF244321}">
                  <p14:modId xmlns:p14="http://schemas.microsoft.com/office/powerpoint/2010/main" val="531549099"/>
                </p:ext>
              </p:extLst>
            </p:nvPr>
          </p:nvGraphicFramePr>
          <p:xfrm>
            <a:off x="2585684" y="2115745"/>
            <a:ext cx="1440160" cy="1600791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</p:grpSp>
      <p:grpSp>
        <p:nvGrpSpPr>
          <p:cNvPr id="53" name="그룹 52"/>
          <p:cNvGrpSpPr/>
          <p:nvPr/>
        </p:nvGrpSpPr>
        <p:grpSpPr>
          <a:xfrm>
            <a:off x="5519563" y="2320635"/>
            <a:ext cx="322049" cy="184666"/>
            <a:chOff x="496713" y="2751366"/>
            <a:chExt cx="322049" cy="184666"/>
          </a:xfrm>
        </p:grpSpPr>
        <p:cxnSp>
          <p:nvCxnSpPr>
            <p:cNvPr id="54" name="직선 연결선 53"/>
            <p:cNvCxnSpPr/>
            <p:nvPr/>
          </p:nvCxnSpPr>
          <p:spPr>
            <a:xfrm>
              <a:off x="746762" y="2852420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5" name="TextBox 54"/>
            <p:cNvSpPr txBox="1"/>
            <p:nvPr/>
          </p:nvSpPr>
          <p:spPr>
            <a:xfrm>
              <a:off x="496713" y="2751366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250</a:t>
              </a:r>
              <a:endParaRPr lang="ko-KR" altLang="en-US" sz="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grpSp>
        <p:nvGrpSpPr>
          <p:cNvPr id="56" name="그룹 55"/>
          <p:cNvGrpSpPr/>
          <p:nvPr/>
        </p:nvGrpSpPr>
        <p:grpSpPr>
          <a:xfrm>
            <a:off x="5564012" y="2401067"/>
            <a:ext cx="277599" cy="184666"/>
            <a:chOff x="541163" y="2764066"/>
            <a:chExt cx="277599" cy="184666"/>
          </a:xfrm>
        </p:grpSpPr>
        <p:cxnSp>
          <p:nvCxnSpPr>
            <p:cNvPr id="57" name="직선 연결선 56"/>
            <p:cNvCxnSpPr/>
            <p:nvPr/>
          </p:nvCxnSpPr>
          <p:spPr>
            <a:xfrm>
              <a:off x="746762" y="2852420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8" name="TextBox 57"/>
            <p:cNvSpPr txBox="1"/>
            <p:nvPr/>
          </p:nvSpPr>
          <p:spPr>
            <a:xfrm>
              <a:off x="541163" y="276406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75</a:t>
              </a:r>
              <a:endParaRPr lang="ko-KR" altLang="en-US" sz="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grpSp>
        <p:nvGrpSpPr>
          <p:cNvPr id="59" name="그룹 58"/>
          <p:cNvGrpSpPr/>
          <p:nvPr/>
        </p:nvGrpSpPr>
        <p:grpSpPr>
          <a:xfrm>
            <a:off x="5564012" y="2677284"/>
            <a:ext cx="277599" cy="184666"/>
            <a:chOff x="541163" y="2760891"/>
            <a:chExt cx="277599" cy="184666"/>
          </a:xfrm>
        </p:grpSpPr>
        <p:cxnSp>
          <p:nvCxnSpPr>
            <p:cNvPr id="60" name="직선 연결선 59"/>
            <p:cNvCxnSpPr/>
            <p:nvPr/>
          </p:nvCxnSpPr>
          <p:spPr>
            <a:xfrm>
              <a:off x="746762" y="2852420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/>
            <p:cNvSpPr txBox="1"/>
            <p:nvPr/>
          </p:nvSpPr>
          <p:spPr>
            <a:xfrm>
              <a:off x="541163" y="2760891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50</a:t>
              </a:r>
              <a:endParaRPr lang="ko-KR" altLang="en-US" sz="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grpSp>
        <p:nvGrpSpPr>
          <p:cNvPr id="62" name="그룹 61"/>
          <p:cNvGrpSpPr/>
          <p:nvPr/>
        </p:nvGrpSpPr>
        <p:grpSpPr>
          <a:xfrm>
            <a:off x="5562954" y="3008016"/>
            <a:ext cx="277599" cy="184666"/>
            <a:chOff x="541163" y="2764066"/>
            <a:chExt cx="277599" cy="184666"/>
          </a:xfrm>
        </p:grpSpPr>
        <p:cxnSp>
          <p:nvCxnSpPr>
            <p:cNvPr id="63" name="직선 연결선 62"/>
            <p:cNvCxnSpPr/>
            <p:nvPr/>
          </p:nvCxnSpPr>
          <p:spPr>
            <a:xfrm>
              <a:off x="746762" y="2852420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TextBox 63"/>
            <p:cNvSpPr txBox="1"/>
            <p:nvPr/>
          </p:nvSpPr>
          <p:spPr>
            <a:xfrm>
              <a:off x="541163" y="276406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50</a:t>
              </a:r>
              <a:endParaRPr lang="ko-KR" altLang="en-US" sz="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grpSp>
        <p:nvGrpSpPr>
          <p:cNvPr id="65" name="그룹 64"/>
          <p:cNvGrpSpPr/>
          <p:nvPr/>
        </p:nvGrpSpPr>
        <p:grpSpPr>
          <a:xfrm>
            <a:off x="5559779" y="3396948"/>
            <a:ext cx="283949" cy="184666"/>
            <a:chOff x="534813" y="2760891"/>
            <a:chExt cx="283949" cy="184666"/>
          </a:xfrm>
        </p:grpSpPr>
        <p:cxnSp>
          <p:nvCxnSpPr>
            <p:cNvPr id="66" name="직선 연결선 65"/>
            <p:cNvCxnSpPr/>
            <p:nvPr/>
          </p:nvCxnSpPr>
          <p:spPr>
            <a:xfrm>
              <a:off x="746762" y="2852420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TextBox 66"/>
            <p:cNvSpPr txBox="1"/>
            <p:nvPr/>
          </p:nvSpPr>
          <p:spPr>
            <a:xfrm>
              <a:off x="534813" y="2760891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37</a:t>
              </a:r>
              <a:endParaRPr lang="ko-KR" altLang="en-US" sz="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grpSp>
        <p:nvGrpSpPr>
          <p:cNvPr id="68" name="그룹 67"/>
          <p:cNvGrpSpPr/>
          <p:nvPr/>
        </p:nvGrpSpPr>
        <p:grpSpPr>
          <a:xfrm>
            <a:off x="5562947" y="3791766"/>
            <a:ext cx="277599" cy="184666"/>
            <a:chOff x="541163" y="2757716"/>
            <a:chExt cx="277599" cy="184666"/>
          </a:xfrm>
        </p:grpSpPr>
        <p:cxnSp>
          <p:nvCxnSpPr>
            <p:cNvPr id="69" name="직선 연결선 68"/>
            <p:cNvCxnSpPr/>
            <p:nvPr/>
          </p:nvCxnSpPr>
          <p:spPr>
            <a:xfrm>
              <a:off x="746762" y="2852420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0" name="TextBox 69"/>
            <p:cNvSpPr txBox="1"/>
            <p:nvPr/>
          </p:nvSpPr>
          <p:spPr>
            <a:xfrm>
              <a:off x="541163" y="275771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75</a:t>
              </a:r>
              <a:endParaRPr lang="ko-KR" altLang="en-US" sz="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grpSp>
        <p:nvGrpSpPr>
          <p:cNvPr id="71" name="그룹 70"/>
          <p:cNvGrpSpPr/>
          <p:nvPr/>
        </p:nvGrpSpPr>
        <p:grpSpPr>
          <a:xfrm>
            <a:off x="5565063" y="4105033"/>
            <a:ext cx="274424" cy="184666"/>
            <a:chOff x="544338" y="2757716"/>
            <a:chExt cx="274424" cy="184666"/>
          </a:xfrm>
        </p:grpSpPr>
        <p:cxnSp>
          <p:nvCxnSpPr>
            <p:cNvPr id="72" name="직선 연결선 71"/>
            <p:cNvCxnSpPr/>
            <p:nvPr/>
          </p:nvCxnSpPr>
          <p:spPr>
            <a:xfrm>
              <a:off x="746762" y="2852420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/>
            <p:cNvSpPr txBox="1"/>
            <p:nvPr/>
          </p:nvSpPr>
          <p:spPr>
            <a:xfrm>
              <a:off x="544338" y="2757716"/>
              <a:ext cx="271228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6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37</a:t>
              </a:r>
              <a:endParaRPr lang="ko-KR" altLang="en-US" sz="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5278461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그룹 30"/>
          <p:cNvGrpSpPr/>
          <p:nvPr/>
        </p:nvGrpSpPr>
        <p:grpSpPr>
          <a:xfrm>
            <a:off x="3219353" y="1190287"/>
            <a:ext cx="3547336" cy="3191167"/>
            <a:chOff x="2406553" y="1075987"/>
            <a:chExt cx="3547336" cy="3191167"/>
          </a:xfrm>
        </p:grpSpPr>
        <p:sp>
          <p:nvSpPr>
            <p:cNvPr id="24" name="직사각형 23"/>
            <p:cNvSpPr/>
            <p:nvPr/>
          </p:nvSpPr>
          <p:spPr>
            <a:xfrm>
              <a:off x="3088965" y="4080626"/>
              <a:ext cx="1008000" cy="144000"/>
            </a:xfrm>
            <a:prstGeom prst="rect">
              <a:avLst/>
            </a:prstGeom>
            <a:solidFill>
              <a:schemeClr val="bg2">
                <a:lumMod val="75000"/>
              </a:schemeClr>
            </a:solidFill>
            <a:ln>
              <a:solidFill>
                <a:schemeClr val="bg2">
                  <a:lumMod val="7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5" name="직사각형 4"/>
            <p:cNvSpPr/>
            <p:nvPr/>
          </p:nvSpPr>
          <p:spPr>
            <a:xfrm>
              <a:off x="3050865" y="2613319"/>
              <a:ext cx="396000" cy="100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6" name="직사각형 5"/>
            <p:cNvSpPr/>
            <p:nvPr/>
          </p:nvSpPr>
          <p:spPr>
            <a:xfrm>
              <a:off x="3050865" y="2429962"/>
              <a:ext cx="396000" cy="100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7" name="직선 연결선 6"/>
            <p:cNvCxnSpPr/>
            <p:nvPr/>
          </p:nvCxnSpPr>
          <p:spPr>
            <a:xfrm>
              <a:off x="3049230" y="2529976"/>
              <a:ext cx="3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직선 연결선 7"/>
            <p:cNvCxnSpPr/>
            <p:nvPr/>
          </p:nvCxnSpPr>
          <p:spPr>
            <a:xfrm>
              <a:off x="3049230" y="2712382"/>
              <a:ext cx="3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직사각형 8"/>
            <p:cNvSpPr/>
            <p:nvPr/>
          </p:nvSpPr>
          <p:spPr>
            <a:xfrm>
              <a:off x="3112780" y="1881711"/>
              <a:ext cx="774000" cy="100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0" name="직선 연결선 9"/>
            <p:cNvCxnSpPr/>
            <p:nvPr/>
          </p:nvCxnSpPr>
          <p:spPr>
            <a:xfrm>
              <a:off x="3111899" y="1982205"/>
              <a:ext cx="77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" name="직사각형 10"/>
            <p:cNvSpPr/>
            <p:nvPr/>
          </p:nvSpPr>
          <p:spPr>
            <a:xfrm>
              <a:off x="5441612" y="1695576"/>
              <a:ext cx="396000" cy="100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2" name="직사각형 11"/>
            <p:cNvSpPr/>
            <p:nvPr/>
          </p:nvSpPr>
          <p:spPr>
            <a:xfrm>
              <a:off x="5441050" y="1514602"/>
              <a:ext cx="396000" cy="1008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cxnSp>
          <p:nvCxnSpPr>
            <p:cNvPr id="13" name="직선 연결선 12"/>
            <p:cNvCxnSpPr/>
            <p:nvPr/>
          </p:nvCxnSpPr>
          <p:spPr>
            <a:xfrm>
              <a:off x="5440169" y="1613007"/>
              <a:ext cx="3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직선 연결선 13"/>
            <p:cNvCxnSpPr/>
            <p:nvPr/>
          </p:nvCxnSpPr>
          <p:spPr>
            <a:xfrm>
              <a:off x="5440169" y="1795412"/>
              <a:ext cx="39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직사각형 14"/>
            <p:cNvSpPr/>
            <p:nvPr/>
          </p:nvSpPr>
          <p:spPr>
            <a:xfrm>
              <a:off x="4612890" y="1328169"/>
              <a:ext cx="774000" cy="99603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ko-KR" altLang="en-US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561735" y="3919159"/>
              <a:ext cx="27443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700" b="1" dirty="0" smtClean="0"/>
                <a:t>+1</a:t>
              </a:r>
              <a:endParaRPr lang="ko-KR" altLang="en-US" sz="7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406553" y="1227416"/>
              <a:ext cx="647934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Human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Mouse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Rat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err="1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Zebrafish</a:t>
              </a:r>
              <a:endParaRPr lang="ko-KR" altLang="en-US" sz="8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409145" y="2148549"/>
              <a:ext cx="647934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Human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Mouse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Rat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err="1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Zebrafish</a:t>
              </a:r>
              <a:endParaRPr lang="ko-KR" altLang="en-US" sz="8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2419242" y="3058729"/>
              <a:ext cx="647934" cy="83099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Human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Mouse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smtClean="0">
                  <a:latin typeface="Arial" pitchFamily="34" charset="0"/>
                  <a:cs typeface="Arial" pitchFamily="34" charset="0"/>
                </a:rPr>
                <a:t>Rat</a:t>
              </a:r>
            </a:p>
            <a:p>
              <a:pPr algn="ctr">
                <a:lnSpc>
                  <a:spcPct val="150000"/>
                </a:lnSpc>
              </a:pPr>
              <a:r>
                <a:rPr lang="en-US" altLang="ko-KR" sz="800" b="1" dirty="0" err="1" smtClean="0">
                  <a:latin typeface="Arial" panose="020B0604020202020204" pitchFamily="34" charset="0"/>
                  <a:ea typeface="Arial Unicode MS" pitchFamily="50" charset="-127"/>
                  <a:cs typeface="Arial" panose="020B0604020202020204" pitchFamily="34" charset="0"/>
                </a:rPr>
                <a:t>Zebrafish</a:t>
              </a:r>
              <a:endParaRPr lang="ko-KR" altLang="en-US" sz="800" b="1" dirty="0">
                <a:latin typeface="Arial" panose="020B0604020202020204" pitchFamily="34" charset="0"/>
                <a:ea typeface="Arial Unicode MS" pitchFamily="50" charset="-127"/>
                <a:cs typeface="Arial" panose="020B0604020202020204" pitchFamily="34" charset="0"/>
              </a:endParaRPr>
            </a:p>
          </p:txBody>
        </p:sp>
        <p:cxnSp>
          <p:nvCxnSpPr>
            <p:cNvPr id="20" name="직선 연결선 19"/>
            <p:cNvCxnSpPr/>
            <p:nvPr/>
          </p:nvCxnSpPr>
          <p:spPr>
            <a:xfrm>
              <a:off x="4611406" y="1429854"/>
              <a:ext cx="774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그룹 260"/>
            <p:cNvGrpSpPr/>
            <p:nvPr/>
          </p:nvGrpSpPr>
          <p:grpSpPr>
            <a:xfrm>
              <a:off x="2892945" y="1075987"/>
              <a:ext cx="346570" cy="328406"/>
              <a:chOff x="499452" y="447986"/>
              <a:chExt cx="346570" cy="328406"/>
            </a:xfrm>
          </p:grpSpPr>
          <p:sp>
            <p:nvSpPr>
              <p:cNvPr id="27" name="TextBox 26"/>
              <p:cNvSpPr txBox="1"/>
              <p:nvPr/>
            </p:nvSpPr>
            <p:spPr>
              <a:xfrm>
                <a:off x="499452" y="447986"/>
                <a:ext cx="346570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700" b="1" dirty="0" smtClean="0"/>
                  <a:t>-147</a:t>
                </a:r>
              </a:p>
              <a:p>
                <a:endParaRPr lang="ko-KR" altLang="en-US" sz="700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547936" y="530171"/>
                <a:ext cx="276038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ko-KR" altLang="en-US" sz="10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↓</a:t>
                </a:r>
                <a:endParaRPr lang="ko-KR" altLang="en-US" sz="10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sp>
          <p:nvSpPr>
            <p:cNvPr id="22" name="TextBox 21"/>
            <p:cNvSpPr txBox="1"/>
            <p:nvPr/>
          </p:nvSpPr>
          <p:spPr>
            <a:xfrm rot="10800000">
              <a:off x="5560131" y="3760265"/>
              <a:ext cx="27603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ko-KR" altLang="en-US" sz="10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↓</a:t>
              </a:r>
              <a:endParaRPr lang="ko-KR" altLang="en-US" sz="10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963968" y="1231218"/>
              <a:ext cx="2989921" cy="267765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AAAACCTCTGGTCGTGTTTCATGGACCCACCTTTCCTAATCCTTGTCCTC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ATCCCTGCACATCTCAAGAGAACCTCTGGTGTTTCCATGGACCACCTTTC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ATCCCTGCACATCTCAAGAGAACCTCTGGTGTTTCCATGGACCACCTTTC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AATGTTCTGCAAGAGCTTTATTGAATGCTTTCTTTTTTCTCGTTGTCTTT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 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TTAATGGTTTCAACAGGACAGATTGATTCACTTTGGAGCTGTAAGTACTG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CTAATCCTTGTCCTCTTAATGGTTTTAACAGGAGAGATTGATTCCCTTGG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CTAATCCTTGTCCTCTTAATGGTTTTAACAGGAGAGATTGATTCCCTTGG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CTCATGCAGGAGGAATTCTTTCGCAGTGGCATTAATAGAAGTCTGGATAT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 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ATGTATTAGGGTGCAGCGCTCATTGTTCCTTGACGCAGAGTCCCAAAATG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GAGCTGTAAGTACTGAGGTATTAGGGTGCAGCGCTCATTGTTCACTGATG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GAGCTGTAAGTACTGAGGTATTAGGGTGCAGCGCTCATTGTTCACTGATG</a:t>
              </a:r>
              <a:endParaRPr lang="ko-KR" altLang="ko-KR" sz="800" dirty="0" smtClean="0">
                <a:latin typeface="Consolas" pitchFamily="49" charset="0"/>
                <a:cs typeface="Consolas" pitchFamily="49" charset="0"/>
              </a:endParaRPr>
            </a:p>
            <a:p>
              <a:pPr>
                <a:lnSpc>
                  <a:spcPct val="150000"/>
                </a:lnSpc>
              </a:pPr>
              <a:r>
                <a:rPr lang="en-US" altLang="ko-KR" sz="800" dirty="0" smtClean="0">
                  <a:latin typeface="Consolas" pitchFamily="49" charset="0"/>
                  <a:cs typeface="Consolas" pitchFamily="49" charset="0"/>
                </a:rPr>
                <a:t>AAACTTTCTGCCTCGTGGGCTGTACTGGGACAGAGTGCAGGGACACTATG</a:t>
              </a:r>
              <a:endParaRPr lang="ko-KR" altLang="en-US" sz="800" dirty="0">
                <a:latin typeface="Consolas" pitchFamily="49" charset="0"/>
                <a:cs typeface="Consolas" pitchFamily="49" charset="0"/>
              </a:endParaRPr>
            </a:p>
          </p:txBody>
        </p:sp>
        <p:cxnSp>
          <p:nvCxnSpPr>
            <p:cNvPr id="25" name="직선 연결선 24"/>
            <p:cNvCxnSpPr/>
            <p:nvPr/>
          </p:nvCxnSpPr>
          <p:spPr>
            <a:xfrm>
              <a:off x="3078877" y="4227846"/>
              <a:ext cx="1026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TextBox 25"/>
            <p:cNvSpPr txBox="1"/>
            <p:nvPr/>
          </p:nvSpPr>
          <p:spPr>
            <a:xfrm>
              <a:off x="3034016" y="4051710"/>
              <a:ext cx="111440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>
                  <a:latin typeface="Times New Roman" panose="02020603050405020304" pitchFamily="18" charset="0"/>
                  <a:ea typeface="Arial Unicode MS" pitchFamily="50" charset="-127"/>
                  <a:cs typeface="Times New Roman" panose="02020603050405020304" pitchFamily="18" charset="0"/>
                </a:rPr>
                <a:t>C/EBP-β binding </a:t>
              </a:r>
              <a:r>
                <a:rPr lang="en-US" altLang="ko-KR" sz="800" b="1" dirty="0" smtClean="0">
                  <a:latin typeface="Times New Roman" panose="02020603050405020304" pitchFamily="18" charset="0"/>
                  <a:ea typeface="Arial Unicode MS" pitchFamily="50" charset="-127"/>
                  <a:cs typeface="Times New Roman" panose="02020603050405020304" pitchFamily="18" charset="0"/>
                </a:rPr>
                <a:t>site</a:t>
              </a:r>
              <a:endParaRPr lang="ko-KR" altLang="en-US" sz="800" b="1" dirty="0">
                <a:latin typeface="Times New Roman" panose="02020603050405020304" pitchFamily="18" charset="0"/>
                <a:ea typeface="Arial Unicode MS" pitchFamily="50" charset="-127"/>
                <a:cs typeface="Times New Roman" panose="02020603050405020304" pitchFamily="18" charset="0"/>
              </a:endParaRPr>
            </a:p>
          </p:txBody>
        </p:sp>
      </p:grpSp>
      <p:sp>
        <p:nvSpPr>
          <p:cNvPr id="29" name="직사각형 28"/>
          <p:cNvSpPr/>
          <p:nvPr/>
        </p:nvSpPr>
        <p:spPr>
          <a:xfrm>
            <a:off x="2772856" y="5159335"/>
            <a:ext cx="4887172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.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/EBP-β binding site in </a:t>
            </a:r>
            <a:r>
              <a:rPr lang="en-US" altLang="ko-KR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XIN1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ene promoter</a:t>
            </a:r>
            <a:endParaRPr lang="ko-KR" altLang="en-US" sz="1200" dirty="0"/>
          </a:p>
        </p:txBody>
      </p:sp>
    </p:spTree>
    <p:extLst>
      <p:ext uri="{BB962C8B-B14F-4D97-AF65-F5344CB8AC3E}">
        <p14:creationId xmlns:p14="http://schemas.microsoft.com/office/powerpoint/2010/main" val="16358203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그룹 2"/>
          <p:cNvGrpSpPr/>
          <p:nvPr/>
        </p:nvGrpSpPr>
        <p:grpSpPr>
          <a:xfrm>
            <a:off x="3304664" y="1952625"/>
            <a:ext cx="2738326" cy="1618655"/>
            <a:chOff x="3195993" y="2121441"/>
            <a:chExt cx="2738326" cy="1618655"/>
          </a:xfrm>
        </p:grpSpPr>
        <p:sp>
          <p:nvSpPr>
            <p:cNvPr id="6" name="TextBox 5"/>
            <p:cNvSpPr txBox="1"/>
            <p:nvPr/>
          </p:nvSpPr>
          <p:spPr>
            <a:xfrm>
              <a:off x="3802575" y="2298288"/>
              <a:ext cx="2423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0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236773" y="2298288"/>
              <a:ext cx="3000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10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709195" y="2298288"/>
              <a:ext cx="3000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20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171488" y="2298288"/>
              <a:ext cx="411883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30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5634238" y="2298288"/>
              <a:ext cx="30008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40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4182989" y="2121441"/>
              <a:ext cx="1340433" cy="19585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Relative Reporter Activity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429625" y="2544120"/>
              <a:ext cx="51007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err="1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pcDNA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3" name="TextBox 12"/>
            <p:cNvSpPr txBox="1"/>
            <p:nvPr/>
          </p:nvSpPr>
          <p:spPr>
            <a:xfrm rot="16200000">
              <a:off x="2671971" y="3000631"/>
              <a:ext cx="126348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pGL3-hAxin1(-1017 </a:t>
              </a:r>
              <a:r>
                <a:rPr lang="en-US" altLang="ko-KR" sz="800" b="1" dirty="0" err="1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bp</a:t>
              </a:r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)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cxnSp>
          <p:nvCxnSpPr>
            <p:cNvPr id="14" name="직선 연결선 13"/>
            <p:cNvCxnSpPr/>
            <p:nvPr/>
          </p:nvCxnSpPr>
          <p:spPr>
            <a:xfrm>
              <a:off x="3414076" y="2516856"/>
              <a:ext cx="0" cy="118800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TextBox 14"/>
            <p:cNvSpPr txBox="1"/>
            <p:nvPr/>
          </p:nvSpPr>
          <p:spPr>
            <a:xfrm>
              <a:off x="3364833" y="2847397"/>
              <a:ext cx="585417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C/EBP-β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3364940" y="3157117"/>
              <a:ext cx="587019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C/EBP-α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3595803" y="3469507"/>
              <a:ext cx="34015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LIP</a:t>
              </a:r>
              <a:endParaRPr lang="ko-KR" altLang="en-US" sz="8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sp>
        <p:nvSpPr>
          <p:cNvPr id="123" name="직사각형 122"/>
          <p:cNvSpPr/>
          <p:nvPr/>
        </p:nvSpPr>
        <p:spPr>
          <a:xfrm>
            <a:off x="729419" y="4590769"/>
            <a:ext cx="843430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/EBP-β up-regulates </a:t>
            </a:r>
            <a:r>
              <a:rPr lang="en-US" altLang="ko-KR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XIN1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gene promoter activity.</a:t>
            </a:r>
            <a:endParaRPr lang="en-US" altLang="ko-KR" sz="1200" dirty="0" smtClean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293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lls were transfected with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Axin-1017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indicated expression plasmids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uciferase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ivities were measured 48 h after transfection and Axin1 promoter activities are reported as relative light unit (RLU) normalized to </a:t>
            </a:r>
            <a:r>
              <a:rPr lang="en-US" altLang="ko-KR" sz="1200" i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Renilla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luciferase activity. Results are the average of three experiments, and bars indicate standard deviations. </a:t>
            </a:r>
            <a:endParaRPr lang="ko-KR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8" name="차트 1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64001337"/>
              </p:ext>
            </p:extLst>
          </p:nvPr>
        </p:nvGraphicFramePr>
        <p:xfrm>
          <a:off x="3898393" y="2201447"/>
          <a:ext cx="2160000" cy="149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:p14="http://schemas.microsoft.com/office/powerpoint/2010/main" val="375143185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/>
          <p:nvPr/>
        </p:nvGrpSpPr>
        <p:grpSpPr>
          <a:xfrm>
            <a:off x="2067014" y="1390501"/>
            <a:ext cx="6014133" cy="2877782"/>
            <a:chOff x="2067014" y="1390501"/>
            <a:chExt cx="6014133" cy="2877782"/>
          </a:xfrm>
        </p:grpSpPr>
        <p:grpSp>
          <p:nvGrpSpPr>
            <p:cNvPr id="103" name="그룹 102"/>
            <p:cNvGrpSpPr/>
            <p:nvPr/>
          </p:nvGrpSpPr>
          <p:grpSpPr>
            <a:xfrm>
              <a:off x="2432748" y="1390501"/>
              <a:ext cx="1529796" cy="506593"/>
              <a:chOff x="3866204" y="389186"/>
              <a:chExt cx="1529796" cy="506593"/>
            </a:xfrm>
          </p:grpSpPr>
          <p:grpSp>
            <p:nvGrpSpPr>
              <p:cNvPr id="111" name="그룹 110"/>
              <p:cNvGrpSpPr/>
              <p:nvPr/>
            </p:nvGrpSpPr>
            <p:grpSpPr>
              <a:xfrm>
                <a:off x="3956000" y="599384"/>
                <a:ext cx="1440000" cy="296395"/>
                <a:chOff x="3956000" y="599384"/>
                <a:chExt cx="1440000" cy="296395"/>
              </a:xfrm>
            </p:grpSpPr>
            <p:cxnSp>
              <p:nvCxnSpPr>
                <p:cNvPr id="113" name="직선 연결선 112"/>
                <p:cNvCxnSpPr/>
                <p:nvPr/>
              </p:nvCxnSpPr>
              <p:spPr>
                <a:xfrm>
                  <a:off x="3956000" y="890215"/>
                  <a:ext cx="1440000" cy="0"/>
                </a:xfrm>
                <a:prstGeom prst="line">
                  <a:avLst/>
                </a:prstGeom>
                <a:ln w="1905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4" name="직선 연결선 113"/>
                <p:cNvCxnSpPr/>
                <p:nvPr/>
              </p:nvCxnSpPr>
              <p:spPr>
                <a:xfrm>
                  <a:off x="4783643" y="763720"/>
                  <a:ext cx="1499" cy="132059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5" name="직선 화살표 연결선 114"/>
                <p:cNvCxnSpPr/>
                <p:nvPr/>
              </p:nvCxnSpPr>
              <p:spPr>
                <a:xfrm>
                  <a:off x="4783643" y="770738"/>
                  <a:ext cx="612000" cy="0"/>
                </a:xfrm>
                <a:prstGeom prst="straightConnector1">
                  <a:avLst/>
                </a:prstGeom>
                <a:ln w="12700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16" name="TextBox 115"/>
                <p:cNvSpPr txBox="1"/>
                <p:nvPr/>
              </p:nvSpPr>
              <p:spPr>
                <a:xfrm>
                  <a:off x="4886116" y="599384"/>
                  <a:ext cx="502061" cy="2000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700" b="1" i="1" dirty="0" smtClean="0">
                      <a:latin typeface="Arial Unicode MS" panose="020B0604020202020204" pitchFamily="50" charset="-127"/>
                      <a:ea typeface="Arial Unicode MS" panose="020B0604020202020204" pitchFamily="50" charset="-127"/>
                      <a:cs typeface="Arial Unicode MS" panose="020B0604020202020204" pitchFamily="50" charset="-127"/>
                    </a:rPr>
                    <a:t>GAPDH</a:t>
                  </a:r>
                  <a:endParaRPr lang="ko-KR" altLang="en-US" sz="700" b="1" i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endParaRPr>
                </a:p>
              </p:txBody>
            </p:sp>
            <p:grpSp>
              <p:nvGrpSpPr>
                <p:cNvPr id="117" name="그룹 116"/>
                <p:cNvGrpSpPr/>
                <p:nvPr/>
              </p:nvGrpSpPr>
              <p:grpSpPr>
                <a:xfrm>
                  <a:off x="4637246" y="716238"/>
                  <a:ext cx="282598" cy="26404"/>
                  <a:chOff x="5041862" y="965223"/>
                  <a:chExt cx="282598" cy="32617"/>
                </a:xfrm>
              </p:grpSpPr>
              <p:grpSp>
                <p:nvGrpSpPr>
                  <p:cNvPr id="118" name="그룹 117"/>
                  <p:cNvGrpSpPr/>
                  <p:nvPr/>
                </p:nvGrpSpPr>
                <p:grpSpPr>
                  <a:xfrm>
                    <a:off x="5041862" y="965223"/>
                    <a:ext cx="106330" cy="32400"/>
                    <a:chOff x="3942496" y="2430496"/>
                    <a:chExt cx="106330" cy="36000"/>
                  </a:xfrm>
                </p:grpSpPr>
                <p:cxnSp>
                  <p:nvCxnSpPr>
                    <p:cNvPr id="122" name="직선 연결선 121"/>
                    <p:cNvCxnSpPr/>
                    <p:nvPr/>
                  </p:nvCxnSpPr>
                  <p:spPr>
                    <a:xfrm>
                      <a:off x="3942496" y="2450548"/>
                      <a:ext cx="72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3" name="이등변 삼각형 122"/>
                    <p:cNvSpPr/>
                    <p:nvPr/>
                  </p:nvSpPr>
                  <p:spPr>
                    <a:xfrm rot="5400000">
                      <a:off x="4012826" y="2430496"/>
                      <a:ext cx="36000" cy="36000"/>
                    </a:xfrm>
                    <a:prstGeom prst="triangle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  <p:grpSp>
                <p:nvGrpSpPr>
                  <p:cNvPr id="119" name="그룹 118"/>
                  <p:cNvGrpSpPr/>
                  <p:nvPr/>
                </p:nvGrpSpPr>
                <p:grpSpPr>
                  <a:xfrm rot="10800000">
                    <a:off x="5216481" y="965441"/>
                    <a:ext cx="107979" cy="32399"/>
                    <a:chOff x="4200702" y="2433778"/>
                    <a:chExt cx="106304" cy="35999"/>
                  </a:xfrm>
                </p:grpSpPr>
                <p:cxnSp>
                  <p:nvCxnSpPr>
                    <p:cNvPr id="120" name="직선 연결선 119"/>
                    <p:cNvCxnSpPr/>
                    <p:nvPr/>
                  </p:nvCxnSpPr>
                  <p:spPr>
                    <a:xfrm>
                      <a:off x="4200702" y="2448393"/>
                      <a:ext cx="72000" cy="0"/>
                    </a:xfrm>
                    <a:prstGeom prst="line">
                      <a:avLst/>
                    </a:prstGeom>
                    <a:ln w="12700">
                      <a:solidFill>
                        <a:schemeClr val="tx1"/>
                      </a:solidFill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sp>
                  <p:nvSpPr>
                    <p:cNvPr id="121" name="이등변 삼각형 120"/>
                    <p:cNvSpPr/>
                    <p:nvPr/>
                  </p:nvSpPr>
                  <p:spPr>
                    <a:xfrm rot="5400000">
                      <a:off x="4271007" y="2433778"/>
                      <a:ext cx="35999" cy="35999"/>
                    </a:xfrm>
                    <a:prstGeom prst="triangle">
                      <a:avLst/>
                    </a:prstGeom>
                    <a:solidFill>
                      <a:schemeClr val="tx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ko-KR" altLang="en-US"/>
                    </a:p>
                  </p:txBody>
                </p:sp>
              </p:grpSp>
            </p:grpSp>
          </p:grpSp>
          <p:sp>
            <p:nvSpPr>
              <p:cNvPr id="112" name="TextBox 111"/>
              <p:cNvSpPr txBox="1"/>
              <p:nvPr/>
            </p:nvSpPr>
            <p:spPr>
              <a:xfrm>
                <a:off x="3866204" y="389186"/>
                <a:ext cx="125066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i="1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GAPDH gene </a:t>
                </a:r>
                <a:r>
                  <a:rPr lang="en-US" altLang="ko-KR" sz="800" b="1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promoter</a:t>
                </a:r>
                <a:endParaRPr lang="ko-KR" altLang="en-US" sz="8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</p:grpSp>
        <p:grpSp>
          <p:nvGrpSpPr>
            <p:cNvPr id="193" name="그룹 192"/>
            <p:cNvGrpSpPr/>
            <p:nvPr/>
          </p:nvGrpSpPr>
          <p:grpSpPr>
            <a:xfrm>
              <a:off x="2254490" y="2287307"/>
              <a:ext cx="1790892" cy="1980976"/>
              <a:chOff x="1714844" y="2227346"/>
              <a:chExt cx="1790892" cy="1980976"/>
            </a:xfrm>
          </p:grpSpPr>
          <p:graphicFrame>
            <p:nvGraphicFramePr>
              <p:cNvPr id="99" name="차트 98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1684823704"/>
                  </p:ext>
                </p:extLst>
              </p:nvPr>
            </p:nvGraphicFramePr>
            <p:xfrm>
              <a:off x="2065736" y="2334312"/>
              <a:ext cx="14400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100" name="TextBox 99"/>
              <p:cNvSpPr txBox="1"/>
              <p:nvPr/>
            </p:nvSpPr>
            <p:spPr>
              <a:xfrm>
                <a:off x="2211783" y="3992878"/>
                <a:ext cx="510076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err="1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pcDNA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01" name="TextBox 100"/>
              <p:cNvSpPr txBox="1"/>
              <p:nvPr/>
            </p:nvSpPr>
            <p:spPr>
              <a:xfrm>
                <a:off x="2815821" y="3991479"/>
                <a:ext cx="585417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/EBP-β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grpSp>
            <p:nvGrpSpPr>
              <p:cNvPr id="102" name="그룹 296"/>
              <p:cNvGrpSpPr/>
              <p:nvPr/>
            </p:nvGrpSpPr>
            <p:grpSpPr>
              <a:xfrm>
                <a:off x="2214958" y="2227346"/>
                <a:ext cx="484428" cy="293360"/>
                <a:chOff x="1757277" y="5955792"/>
                <a:chExt cx="533369" cy="313062"/>
              </a:xfrm>
            </p:grpSpPr>
            <p:sp>
              <p:nvSpPr>
                <p:cNvPr id="124" name="직사각형 123"/>
                <p:cNvSpPr/>
                <p:nvPr/>
              </p:nvSpPr>
              <p:spPr>
                <a:xfrm>
                  <a:off x="1763688" y="6021288"/>
                  <a:ext cx="72008" cy="72008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60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25" name="직사각형 124"/>
                <p:cNvSpPr/>
                <p:nvPr/>
              </p:nvSpPr>
              <p:spPr>
                <a:xfrm>
                  <a:off x="1763688" y="6135588"/>
                  <a:ext cx="72008" cy="72008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60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26" name="TextBox 125"/>
                <p:cNvSpPr txBox="1"/>
                <p:nvPr/>
              </p:nvSpPr>
              <p:spPr>
                <a:xfrm>
                  <a:off x="1758674" y="5955792"/>
                  <a:ext cx="339224" cy="197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 err="1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IgG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27" name="TextBox 126"/>
                <p:cNvSpPr txBox="1"/>
                <p:nvPr/>
              </p:nvSpPr>
              <p:spPr>
                <a:xfrm>
                  <a:off x="1757277" y="6071786"/>
                  <a:ext cx="533369" cy="197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C/EBP-β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  <p:grpSp>
            <p:nvGrpSpPr>
              <p:cNvPr id="104" name="그룹 103"/>
              <p:cNvGrpSpPr/>
              <p:nvPr/>
            </p:nvGrpSpPr>
            <p:grpSpPr>
              <a:xfrm>
                <a:off x="1714844" y="2350160"/>
                <a:ext cx="457797" cy="1790029"/>
                <a:chOff x="1101375" y="1775056"/>
                <a:chExt cx="457797" cy="1790029"/>
              </a:xfrm>
            </p:grpSpPr>
            <p:sp>
              <p:nvSpPr>
                <p:cNvPr id="106" name="TextBox 105"/>
                <p:cNvSpPr txBox="1"/>
                <p:nvPr/>
              </p:nvSpPr>
              <p:spPr>
                <a:xfrm>
                  <a:off x="1315915" y="331997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0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1227692" y="2806578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0.5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08" name="TextBox 107"/>
                <p:cNvSpPr txBox="1"/>
                <p:nvPr/>
              </p:nvSpPr>
              <p:spPr>
                <a:xfrm>
                  <a:off x="1316798" y="228930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09" name="TextBox 108"/>
                <p:cNvSpPr txBox="1"/>
                <p:nvPr/>
              </p:nvSpPr>
              <p:spPr>
                <a:xfrm rot="16200000">
                  <a:off x="314082" y="2562349"/>
                  <a:ext cx="179002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b="1" dirty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Relative promoter enrichment (Fold)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10" name="TextBox 109"/>
                <p:cNvSpPr txBox="1"/>
                <p:nvPr/>
              </p:nvSpPr>
              <p:spPr>
                <a:xfrm>
                  <a:off x="1224727" y="1782112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.5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</p:grpSp>
        <p:sp>
          <p:nvSpPr>
            <p:cNvPr id="105" name="TextBox 104"/>
            <p:cNvSpPr txBox="1"/>
            <p:nvPr/>
          </p:nvSpPr>
          <p:spPr>
            <a:xfrm>
              <a:off x="2067014" y="1958057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a</a:t>
              </a:r>
              <a:endParaRPr lang="ko-KR" altLang="en-US" sz="14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grpSp>
          <p:nvGrpSpPr>
            <p:cNvPr id="192" name="그룹 191"/>
            <p:cNvGrpSpPr/>
            <p:nvPr/>
          </p:nvGrpSpPr>
          <p:grpSpPr>
            <a:xfrm>
              <a:off x="4284631" y="2392310"/>
              <a:ext cx="1783024" cy="1874574"/>
              <a:chOff x="3725935" y="2332349"/>
              <a:chExt cx="1783024" cy="1874574"/>
            </a:xfrm>
          </p:grpSpPr>
          <p:graphicFrame>
            <p:nvGraphicFramePr>
              <p:cNvPr id="130" name="차트 12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950327720"/>
                  </p:ext>
                </p:extLst>
              </p:nvPr>
            </p:nvGraphicFramePr>
            <p:xfrm>
              <a:off x="4068959" y="2332349"/>
              <a:ext cx="14400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31" name="TextBox 130"/>
              <p:cNvSpPr txBox="1"/>
              <p:nvPr/>
            </p:nvSpPr>
            <p:spPr>
              <a:xfrm>
                <a:off x="4199716" y="3989694"/>
                <a:ext cx="5325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No MDI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4920505" y="3991479"/>
                <a:ext cx="37221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MDI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grpSp>
            <p:nvGrpSpPr>
              <p:cNvPr id="133" name="그룹 296"/>
              <p:cNvGrpSpPr/>
              <p:nvPr/>
            </p:nvGrpSpPr>
            <p:grpSpPr>
              <a:xfrm>
                <a:off x="5022909" y="2394543"/>
                <a:ext cx="484428" cy="293360"/>
                <a:chOff x="1757277" y="5962568"/>
                <a:chExt cx="533369" cy="313062"/>
              </a:xfrm>
            </p:grpSpPr>
            <p:sp>
              <p:nvSpPr>
                <p:cNvPr id="142" name="직사각형 141"/>
                <p:cNvSpPr/>
                <p:nvPr/>
              </p:nvSpPr>
              <p:spPr>
                <a:xfrm>
                  <a:off x="1763688" y="6021288"/>
                  <a:ext cx="72008" cy="72008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60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43" name="직사각형 142"/>
                <p:cNvSpPr/>
                <p:nvPr/>
              </p:nvSpPr>
              <p:spPr>
                <a:xfrm>
                  <a:off x="1763688" y="6135588"/>
                  <a:ext cx="72008" cy="72008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60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44" name="TextBox 143"/>
                <p:cNvSpPr txBox="1"/>
                <p:nvPr/>
              </p:nvSpPr>
              <p:spPr>
                <a:xfrm>
                  <a:off x="1758674" y="5962568"/>
                  <a:ext cx="339224" cy="197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 err="1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IgG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45" name="TextBox 144"/>
                <p:cNvSpPr txBox="1"/>
                <p:nvPr/>
              </p:nvSpPr>
              <p:spPr>
                <a:xfrm>
                  <a:off x="1757277" y="6078562"/>
                  <a:ext cx="533369" cy="197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C/EBP-β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  <p:grpSp>
            <p:nvGrpSpPr>
              <p:cNvPr id="134" name="그룹 133"/>
              <p:cNvGrpSpPr/>
              <p:nvPr/>
            </p:nvGrpSpPr>
            <p:grpSpPr>
              <a:xfrm>
                <a:off x="3725935" y="2342298"/>
                <a:ext cx="451979" cy="1790029"/>
                <a:chOff x="1108995" y="1775056"/>
                <a:chExt cx="451979" cy="1790029"/>
              </a:xfrm>
            </p:grpSpPr>
            <p:sp>
              <p:nvSpPr>
                <p:cNvPr id="136" name="TextBox 135"/>
                <p:cNvSpPr txBox="1"/>
                <p:nvPr/>
              </p:nvSpPr>
              <p:spPr>
                <a:xfrm>
                  <a:off x="1315915" y="331997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0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37" name="TextBox 136"/>
                <p:cNvSpPr txBox="1"/>
                <p:nvPr/>
              </p:nvSpPr>
              <p:spPr>
                <a:xfrm>
                  <a:off x="1227692" y="2943738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0.5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38" name="TextBox 137"/>
                <p:cNvSpPr txBox="1"/>
                <p:nvPr/>
              </p:nvSpPr>
              <p:spPr>
                <a:xfrm>
                  <a:off x="1316798" y="255600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39" name="TextBox 138"/>
                <p:cNvSpPr txBox="1"/>
                <p:nvPr/>
              </p:nvSpPr>
              <p:spPr>
                <a:xfrm rot="16200000">
                  <a:off x="321702" y="2562349"/>
                  <a:ext cx="179002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b="1" dirty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Relative promoter enrichment (Fold)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40" name="TextBox 139"/>
                <p:cNvSpPr txBox="1"/>
                <p:nvPr/>
              </p:nvSpPr>
              <p:spPr>
                <a:xfrm>
                  <a:off x="1224727" y="2170732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.5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41" name="TextBox 140"/>
                <p:cNvSpPr txBox="1"/>
                <p:nvPr/>
              </p:nvSpPr>
              <p:spPr>
                <a:xfrm>
                  <a:off x="1318600" y="178507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</p:grpSp>
        <p:sp>
          <p:nvSpPr>
            <p:cNvPr id="135" name="TextBox 134"/>
            <p:cNvSpPr txBox="1"/>
            <p:nvPr/>
          </p:nvSpPr>
          <p:spPr>
            <a:xfrm>
              <a:off x="4116311" y="1967482"/>
              <a:ext cx="28405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b</a:t>
              </a:r>
              <a:endParaRPr lang="ko-KR" altLang="en-US" sz="14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grpSp>
          <p:nvGrpSpPr>
            <p:cNvPr id="191" name="그룹 190"/>
            <p:cNvGrpSpPr/>
            <p:nvPr/>
          </p:nvGrpSpPr>
          <p:grpSpPr>
            <a:xfrm>
              <a:off x="6305246" y="2389713"/>
              <a:ext cx="1775901" cy="1875386"/>
              <a:chOff x="5737025" y="2329752"/>
              <a:chExt cx="1775901" cy="1875386"/>
            </a:xfrm>
          </p:grpSpPr>
          <p:graphicFrame>
            <p:nvGraphicFramePr>
              <p:cNvPr id="160" name="차트 159"/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77298334"/>
                  </p:ext>
                </p:extLst>
              </p:nvPr>
            </p:nvGraphicFramePr>
            <p:xfrm>
              <a:off x="6072926" y="2329752"/>
              <a:ext cx="1440000" cy="1800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61" name="TextBox 160"/>
              <p:cNvSpPr txBox="1"/>
              <p:nvPr/>
            </p:nvSpPr>
            <p:spPr>
              <a:xfrm>
                <a:off x="6234136" y="3989694"/>
                <a:ext cx="492443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DMSO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162" name="TextBox 161"/>
              <p:cNvSpPr txBox="1"/>
              <p:nvPr/>
            </p:nvSpPr>
            <p:spPr>
              <a:xfrm>
                <a:off x="6950214" y="3988315"/>
                <a:ext cx="30489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err="1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Tg</a:t>
                </a:r>
                <a:endParaRPr lang="ko-KR" altLang="en-US" sz="8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grpSp>
            <p:nvGrpSpPr>
              <p:cNvPr id="163" name="그룹 296"/>
              <p:cNvGrpSpPr/>
              <p:nvPr/>
            </p:nvGrpSpPr>
            <p:grpSpPr>
              <a:xfrm>
                <a:off x="6223618" y="2385149"/>
                <a:ext cx="484428" cy="293360"/>
                <a:chOff x="1757277" y="5957485"/>
                <a:chExt cx="533369" cy="313062"/>
              </a:xfrm>
            </p:grpSpPr>
            <p:sp>
              <p:nvSpPr>
                <p:cNvPr id="185" name="직사각형 184"/>
                <p:cNvSpPr/>
                <p:nvPr/>
              </p:nvSpPr>
              <p:spPr>
                <a:xfrm>
                  <a:off x="1763688" y="6021288"/>
                  <a:ext cx="72008" cy="72008"/>
                </a:xfrm>
                <a:prstGeom prst="rect">
                  <a:avLst/>
                </a:prstGeom>
                <a:solidFill>
                  <a:schemeClr val="bg1"/>
                </a:solidFill>
                <a:ln w="6350">
                  <a:solidFill>
                    <a:schemeClr val="tx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60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86" name="직사각형 185"/>
                <p:cNvSpPr/>
                <p:nvPr/>
              </p:nvSpPr>
              <p:spPr>
                <a:xfrm>
                  <a:off x="1763688" y="6135588"/>
                  <a:ext cx="72008" cy="72008"/>
                </a:xfrm>
                <a:prstGeom prst="rect">
                  <a:avLst/>
                </a:prstGeom>
                <a:solidFill>
                  <a:schemeClr val="tx1"/>
                </a:solidFill>
                <a:ln w="6350"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ko-KR" altLang="en-US" sz="60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87" name="TextBox 186"/>
                <p:cNvSpPr txBox="1"/>
                <p:nvPr/>
              </p:nvSpPr>
              <p:spPr>
                <a:xfrm>
                  <a:off x="1758674" y="5957485"/>
                  <a:ext cx="339224" cy="197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 err="1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IgG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88" name="TextBox 187"/>
                <p:cNvSpPr txBox="1"/>
                <p:nvPr/>
              </p:nvSpPr>
              <p:spPr>
                <a:xfrm>
                  <a:off x="1757277" y="6073479"/>
                  <a:ext cx="533369" cy="19706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6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C/EBP-β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  <p:grpSp>
            <p:nvGrpSpPr>
              <p:cNvPr id="165" name="그룹 164"/>
              <p:cNvGrpSpPr/>
              <p:nvPr/>
            </p:nvGrpSpPr>
            <p:grpSpPr>
              <a:xfrm>
                <a:off x="5737025" y="2350308"/>
                <a:ext cx="451979" cy="1790029"/>
                <a:chOff x="1108995" y="1775056"/>
                <a:chExt cx="451979" cy="1790029"/>
              </a:xfrm>
            </p:grpSpPr>
            <p:sp>
              <p:nvSpPr>
                <p:cNvPr id="166" name="TextBox 165"/>
                <p:cNvSpPr txBox="1"/>
                <p:nvPr/>
              </p:nvSpPr>
              <p:spPr>
                <a:xfrm>
                  <a:off x="1315915" y="331997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0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67" name="TextBox 166"/>
                <p:cNvSpPr txBox="1"/>
                <p:nvPr/>
              </p:nvSpPr>
              <p:spPr>
                <a:xfrm>
                  <a:off x="1227692" y="2943738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0.5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68" name="TextBox 167"/>
                <p:cNvSpPr txBox="1"/>
                <p:nvPr/>
              </p:nvSpPr>
              <p:spPr>
                <a:xfrm>
                  <a:off x="1316798" y="2556000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69" name="TextBox 168"/>
                <p:cNvSpPr txBox="1"/>
                <p:nvPr/>
              </p:nvSpPr>
              <p:spPr>
                <a:xfrm rot="16200000">
                  <a:off x="321702" y="2562349"/>
                  <a:ext cx="179002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altLang="ko-KR" sz="800" b="1" dirty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Relative promoter enrichment (Fold)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70" name="TextBox 169"/>
                <p:cNvSpPr txBox="1"/>
                <p:nvPr/>
              </p:nvSpPr>
              <p:spPr>
                <a:xfrm>
                  <a:off x="1224727" y="2170732"/>
                  <a:ext cx="32893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.5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  <p:sp>
              <p:nvSpPr>
                <p:cNvPr id="171" name="TextBox 170"/>
                <p:cNvSpPr txBox="1"/>
                <p:nvPr/>
              </p:nvSpPr>
              <p:spPr>
                <a:xfrm>
                  <a:off x="1318600" y="1785072"/>
                  <a:ext cx="242374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altLang="ko-KR" sz="8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2</a:t>
                  </a:r>
                  <a:endParaRPr lang="ko-KR" altLang="en-US" sz="8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</p:grpSp>
        <p:sp>
          <p:nvSpPr>
            <p:cNvPr id="189" name="TextBox 188"/>
            <p:cNvSpPr txBox="1"/>
            <p:nvPr/>
          </p:nvSpPr>
          <p:spPr>
            <a:xfrm>
              <a:off x="6122419" y="1954774"/>
              <a:ext cx="27443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14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c</a:t>
              </a:r>
              <a:endParaRPr lang="ko-KR" altLang="en-US" sz="14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  <p:sp>
        <p:nvSpPr>
          <p:cNvPr id="190" name="직사각형 189"/>
          <p:cNvSpPr/>
          <p:nvPr/>
        </p:nvSpPr>
        <p:spPr>
          <a:xfrm>
            <a:off x="813307" y="4787820"/>
            <a:ext cx="8599751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 significant occupancy of C/EBPβ on the GAPDH gene promoter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 eaLnBrk="0" hangingPunct="0">
              <a:lnSpc>
                <a:spcPct val="150000"/>
              </a:lnSpc>
            </a:pP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-c,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Chromatin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amples were prepared from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293 cells (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, 3T3-L1 cells (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an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Huh-7 cells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(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subjected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o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P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alysis with anti-C/EBP-β antibody or control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gG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tibody. The amounts of </a:t>
            </a:r>
            <a:r>
              <a:rPr lang="en-US" altLang="ko-KR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immunoprecipitated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GAPDH promoter regions were quantified by real-time PCR. 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Results </a:t>
            </a:r>
            <a:r>
              <a:rPr lang="en-US" altLang="ko-KR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re the average of three experiments, and bars indicate standard deviations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7590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0" name="직사각형 189"/>
          <p:cNvSpPr/>
          <p:nvPr/>
        </p:nvSpPr>
        <p:spPr>
          <a:xfrm>
            <a:off x="813307" y="4787820"/>
            <a:ext cx="8521193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6. C/EBP-β </a:t>
            </a:r>
            <a:r>
              <a:rPr lang="en-US" altLang="ko-KR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motes β-catenin </a:t>
            </a:r>
            <a:r>
              <a:rPr lang="en-US" altLang="ko-KR" sz="1200" b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biquitination</a:t>
            </a:r>
            <a:r>
              <a:rPr lang="en-US" altLang="ko-KR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endParaRPr lang="ko-KR" altLang="ko-KR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just">
              <a:lnSpc>
                <a:spcPct val="150000"/>
              </a:lnSpc>
            </a:pP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EK293 cells were 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transfected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with β-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tenin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-Flag, C/EBP-β and HA-</a:t>
            </a:r>
            <a:r>
              <a:rPr lang="en-US" altLang="ko-KR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biquitin</a:t>
            </a:r>
            <a:r>
              <a:rPr lang="en-US" altLang="ko-KR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plasmids for 24 h, and cells were exposed to MG132 (10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 for 8 hr. Whole cell lysates were subjected to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immunoprecipitation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with an anti-Flag antibody and then analyzed by western blot with indicated antibodies.</a:t>
            </a:r>
            <a:endParaRPr lang="ko-KR" altLang="en-US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499" name="그룹 498"/>
          <p:cNvGrpSpPr/>
          <p:nvPr/>
        </p:nvGrpSpPr>
        <p:grpSpPr>
          <a:xfrm>
            <a:off x="3576172" y="1516380"/>
            <a:ext cx="2436008" cy="2682535"/>
            <a:chOff x="3528547" y="1163955"/>
            <a:chExt cx="2436008" cy="2682535"/>
          </a:xfrm>
        </p:grpSpPr>
        <p:grpSp>
          <p:nvGrpSpPr>
            <p:cNvPr id="496" name="그룹 495"/>
            <p:cNvGrpSpPr/>
            <p:nvPr/>
          </p:nvGrpSpPr>
          <p:grpSpPr>
            <a:xfrm>
              <a:off x="3528547" y="1163955"/>
              <a:ext cx="2436008" cy="2682535"/>
              <a:chOff x="4641067" y="1438275"/>
              <a:chExt cx="2436008" cy="2682535"/>
            </a:xfrm>
          </p:grpSpPr>
          <p:sp>
            <p:nvSpPr>
              <p:cNvPr id="435" name="TextBox 131"/>
              <p:cNvSpPr txBox="1"/>
              <p:nvPr/>
            </p:nvSpPr>
            <p:spPr>
              <a:xfrm>
                <a:off x="4780309" y="1646029"/>
                <a:ext cx="758541" cy="20005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β-</a:t>
                </a:r>
                <a:r>
                  <a:rPr lang="en-US" altLang="ko-KR" sz="700" b="1" dirty="0" err="1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atenin</a:t>
                </a:r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-Flag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pic>
            <p:nvPicPr>
              <p:cNvPr id="413" name="Picture 2"/>
              <p:cNvPicPr preferRelativeResize="0">
                <a:picLocks noChangeArrowheads="1"/>
              </p:cNvPicPr>
              <p:nvPr/>
            </p:nvPicPr>
            <p:blipFill>
              <a:blip r:embed="rId2" cstate="print">
                <a:lum bright="10000"/>
              </a:blip>
              <a:srcRect l="1748" t="22319" r="11677" b="18160"/>
              <a:stretch>
                <a:fillRect/>
              </a:stretch>
            </p:blipFill>
            <p:spPr bwMode="auto">
              <a:xfrm>
                <a:off x="5533677" y="2785431"/>
                <a:ext cx="1045472" cy="2666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14" name="Picture 4"/>
              <p:cNvPicPr preferRelativeResize="0">
                <a:picLocks noChangeArrowheads="1"/>
              </p:cNvPicPr>
              <p:nvPr/>
            </p:nvPicPr>
            <p:blipFill>
              <a:blip r:embed="rId3" cstate="print">
                <a:lum bright="10000"/>
              </a:blip>
              <a:srcRect l="22501" t="14285" r="9996" b="28571"/>
              <a:stretch>
                <a:fillRect/>
              </a:stretch>
            </p:blipFill>
            <p:spPr bwMode="auto">
              <a:xfrm>
                <a:off x="5534907" y="2118729"/>
                <a:ext cx="1045472" cy="59996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15" name="Picture 2"/>
              <p:cNvPicPr preferRelativeResize="0">
                <a:picLocks noChangeArrowheads="1"/>
              </p:cNvPicPr>
              <p:nvPr/>
            </p:nvPicPr>
            <p:blipFill>
              <a:blip r:embed="rId4" cstate="print">
                <a:lum bright="10000"/>
              </a:blip>
              <a:srcRect l="6927" t="23809" r="15875" b="19047"/>
              <a:stretch>
                <a:fillRect/>
              </a:stretch>
            </p:blipFill>
            <p:spPr bwMode="auto">
              <a:xfrm>
                <a:off x="5533794" y="3156056"/>
                <a:ext cx="1045472" cy="2666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16" name="Picture 9"/>
              <p:cNvPicPr preferRelativeResize="0">
                <a:picLocks noChangeArrowheads="1"/>
              </p:cNvPicPr>
              <p:nvPr/>
            </p:nvPicPr>
            <p:blipFill>
              <a:blip r:embed="rId5" cstate="print">
                <a:lum bright="10000"/>
              </a:blip>
              <a:srcRect l="26069" t="392" r="3406" b="28400"/>
              <a:stretch>
                <a:fillRect/>
              </a:stretch>
            </p:blipFill>
            <p:spPr bwMode="auto">
              <a:xfrm>
                <a:off x="5524397" y="3461511"/>
                <a:ext cx="1045472" cy="26668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pic>
            <p:nvPicPr>
              <p:cNvPr id="417" name="Picture 8"/>
              <p:cNvPicPr preferRelativeResize="0">
                <a:picLocks noChangeArrowheads="1"/>
              </p:cNvPicPr>
              <p:nvPr/>
            </p:nvPicPr>
            <p:blipFill>
              <a:blip r:embed="rId6" cstate="print">
                <a:lum bright="10000"/>
              </a:blip>
              <a:srcRect l="6704" t="16626" r="10915" b="22823"/>
              <a:stretch>
                <a:fillRect/>
              </a:stretch>
            </p:blipFill>
            <p:spPr bwMode="auto">
              <a:xfrm>
                <a:off x="5531094" y="3785515"/>
                <a:ext cx="1045472" cy="26665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18" name="TextBox 159"/>
              <p:cNvSpPr txBox="1"/>
              <p:nvPr/>
            </p:nvSpPr>
            <p:spPr>
              <a:xfrm>
                <a:off x="6536740" y="3797431"/>
                <a:ext cx="441009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l-GR" altLang="ko-KR" sz="7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β</a:t>
                </a:r>
                <a:r>
                  <a:rPr lang="en-US" altLang="ko-KR" sz="7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-actin</a:t>
                </a:r>
                <a:endParaRPr lang="ko-KR" altLang="en-US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419" name="TextBox 160"/>
              <p:cNvSpPr txBox="1"/>
              <p:nvPr/>
            </p:nvSpPr>
            <p:spPr>
              <a:xfrm>
                <a:off x="6539912" y="3483377"/>
                <a:ext cx="517045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C/EBP-β</a:t>
                </a:r>
                <a:endParaRPr lang="ko-KR" altLang="en-US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420" name="TextBox 162"/>
              <p:cNvSpPr txBox="1"/>
              <p:nvPr/>
            </p:nvSpPr>
            <p:spPr>
              <a:xfrm>
                <a:off x="5798610" y="1438275"/>
                <a:ext cx="464285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MG132</a:t>
                </a:r>
                <a:endParaRPr lang="ko-KR" altLang="en-US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cxnSp>
            <p:nvCxnSpPr>
              <p:cNvPr id="421" name="직선 연결선 420"/>
              <p:cNvCxnSpPr/>
              <p:nvPr/>
            </p:nvCxnSpPr>
            <p:spPr>
              <a:xfrm>
                <a:off x="5626002" y="1644982"/>
                <a:ext cx="871227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2" name="직사각형 421"/>
              <p:cNvSpPr/>
              <p:nvPr/>
            </p:nvSpPr>
            <p:spPr>
              <a:xfrm>
                <a:off x="5530373" y="3777374"/>
                <a:ext cx="1045472" cy="26665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700" b="1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23" name="직사각형 422"/>
              <p:cNvSpPr/>
              <p:nvPr/>
            </p:nvSpPr>
            <p:spPr>
              <a:xfrm>
                <a:off x="5533100" y="2109058"/>
                <a:ext cx="1045472" cy="599966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700" b="1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24" name="TextBox 171"/>
              <p:cNvSpPr txBox="1"/>
              <p:nvPr/>
            </p:nvSpPr>
            <p:spPr>
              <a:xfrm>
                <a:off x="6539857" y="3168202"/>
                <a:ext cx="537218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l-GR" altLang="ko-KR" sz="7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β</a:t>
                </a:r>
                <a:r>
                  <a:rPr lang="en-US" altLang="ko-KR" sz="700" b="1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-catenin</a:t>
                </a:r>
                <a:endParaRPr lang="ko-KR" altLang="en-US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425" name="직사각형 424"/>
              <p:cNvSpPr/>
              <p:nvPr/>
            </p:nvSpPr>
            <p:spPr>
              <a:xfrm>
                <a:off x="5531036" y="3468948"/>
                <a:ext cx="1045472" cy="26665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700" b="1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26" name="직사각형 425"/>
              <p:cNvSpPr/>
              <p:nvPr/>
            </p:nvSpPr>
            <p:spPr>
              <a:xfrm>
                <a:off x="5530524" y="2786896"/>
                <a:ext cx="1045472" cy="26665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700" b="1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27" name="직사각형 426"/>
              <p:cNvSpPr/>
              <p:nvPr/>
            </p:nvSpPr>
            <p:spPr>
              <a:xfrm>
                <a:off x="5529669" y="3155141"/>
                <a:ext cx="1045472" cy="266651"/>
              </a:xfrm>
              <a:prstGeom prst="rect">
                <a:avLst/>
              </a:prstGeom>
              <a:noFill/>
              <a:ln w="19050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endParaRPr lang="ko-KR" altLang="en-US" sz="700" b="1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cxnSp>
            <p:nvCxnSpPr>
              <p:cNvPr id="428" name="직선 연결선 427"/>
              <p:cNvCxnSpPr/>
              <p:nvPr/>
            </p:nvCxnSpPr>
            <p:spPr>
              <a:xfrm>
                <a:off x="5202404" y="3177190"/>
                <a:ext cx="0" cy="86671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29" name="TextBox 174"/>
              <p:cNvSpPr txBox="1"/>
              <p:nvPr/>
            </p:nvSpPr>
            <p:spPr>
              <a:xfrm>
                <a:off x="4807223" y="3177190"/>
                <a:ext cx="372732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Input</a:t>
                </a:r>
                <a:endParaRPr lang="ko-KR" altLang="en-US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cxnSp>
            <p:nvCxnSpPr>
              <p:cNvPr id="430" name="직선 연결선 429"/>
              <p:cNvCxnSpPr/>
              <p:nvPr/>
            </p:nvCxnSpPr>
            <p:spPr>
              <a:xfrm>
                <a:off x="5202949" y="2135484"/>
                <a:ext cx="0" cy="89994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31" name="TextBox 174"/>
              <p:cNvSpPr txBox="1"/>
              <p:nvPr/>
            </p:nvSpPr>
            <p:spPr>
              <a:xfrm>
                <a:off x="4641067" y="2122254"/>
                <a:ext cx="503079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IP : Flag</a:t>
                </a:r>
                <a:endParaRPr lang="ko-KR" altLang="en-US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432" name="TextBox 171"/>
              <p:cNvSpPr txBox="1"/>
              <p:nvPr/>
            </p:nvSpPr>
            <p:spPr>
              <a:xfrm>
                <a:off x="6535302" y="2822980"/>
                <a:ext cx="537218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l-GR" altLang="ko-KR" sz="700" b="1" dirty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β</a:t>
                </a:r>
                <a:r>
                  <a:rPr lang="en-US" altLang="ko-KR" sz="700" b="1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-catenin</a:t>
                </a:r>
                <a:endParaRPr lang="ko-KR" altLang="en-US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433" name="TextBox 171"/>
              <p:cNvSpPr txBox="1"/>
              <p:nvPr/>
            </p:nvSpPr>
            <p:spPr>
              <a:xfrm>
                <a:off x="6539367" y="2095974"/>
                <a:ext cx="298248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anose="020B0604020202020204" pitchFamily="50" charset="-127"/>
                    <a:ea typeface="Arial Unicode MS" panose="020B0604020202020204" pitchFamily="50" charset="-127"/>
                    <a:cs typeface="Arial Unicode MS" panose="020B0604020202020204" pitchFamily="50" charset="-127"/>
                  </a:rPr>
                  <a:t>HA</a:t>
                </a:r>
                <a:endParaRPr lang="ko-KR" altLang="en-US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endParaRPr>
              </a:p>
            </p:txBody>
          </p:sp>
          <p:sp>
            <p:nvSpPr>
              <p:cNvPr id="434" name="TextBox 130"/>
              <p:cNvSpPr txBox="1"/>
              <p:nvPr/>
            </p:nvSpPr>
            <p:spPr>
              <a:xfrm>
                <a:off x="4998744" y="1785699"/>
                <a:ext cx="517045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C/EBP-β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36" name="TextBox 133"/>
              <p:cNvSpPr txBox="1"/>
              <p:nvPr/>
            </p:nvSpPr>
            <p:spPr>
              <a:xfrm>
                <a:off x="5639128" y="1647450"/>
                <a:ext cx="208245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-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37" name="TextBox 134"/>
              <p:cNvSpPr txBox="1"/>
              <p:nvPr/>
            </p:nvSpPr>
            <p:spPr>
              <a:xfrm>
                <a:off x="6245048" y="1910996"/>
                <a:ext cx="229971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38" name="TextBox 135"/>
              <p:cNvSpPr txBox="1"/>
              <p:nvPr/>
            </p:nvSpPr>
            <p:spPr>
              <a:xfrm>
                <a:off x="5629886" y="1905769"/>
                <a:ext cx="229971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39" name="TextBox 136"/>
              <p:cNvSpPr txBox="1"/>
              <p:nvPr/>
            </p:nvSpPr>
            <p:spPr>
              <a:xfrm>
                <a:off x="5939379" y="1910498"/>
                <a:ext cx="229971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40" name="TextBox 137"/>
              <p:cNvSpPr txBox="1"/>
              <p:nvPr/>
            </p:nvSpPr>
            <p:spPr>
              <a:xfrm>
                <a:off x="5938844" y="1657583"/>
                <a:ext cx="229971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41" name="TextBox 138"/>
              <p:cNvSpPr txBox="1"/>
              <p:nvPr/>
            </p:nvSpPr>
            <p:spPr>
              <a:xfrm>
                <a:off x="6245897" y="1656268"/>
                <a:ext cx="229971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42" name="TextBox 141"/>
              <p:cNvSpPr txBox="1"/>
              <p:nvPr/>
            </p:nvSpPr>
            <p:spPr>
              <a:xfrm>
                <a:off x="6246211" y="1783937"/>
                <a:ext cx="229971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+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43" name="TextBox 142"/>
              <p:cNvSpPr txBox="1"/>
              <p:nvPr/>
            </p:nvSpPr>
            <p:spPr>
              <a:xfrm>
                <a:off x="5951375" y="1773014"/>
                <a:ext cx="208245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-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44" name="TextBox 143"/>
              <p:cNvSpPr txBox="1"/>
              <p:nvPr/>
            </p:nvSpPr>
            <p:spPr>
              <a:xfrm>
                <a:off x="5638845" y="1773014"/>
                <a:ext cx="208245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-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sp>
            <p:nvSpPr>
              <p:cNvPr id="445" name="TextBox 130"/>
              <p:cNvSpPr txBox="1"/>
              <p:nvPr/>
            </p:nvSpPr>
            <p:spPr>
              <a:xfrm>
                <a:off x="5077758" y="1909164"/>
                <a:ext cx="437906" cy="18522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7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HA-</a:t>
                </a:r>
                <a:r>
                  <a:rPr lang="en-US" altLang="ko-KR" sz="700" b="1" dirty="0" err="1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Ub</a:t>
                </a:r>
                <a:endParaRPr lang="ko-KR" altLang="en-US" sz="7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  <p:grpSp>
            <p:nvGrpSpPr>
              <p:cNvPr id="452" name="그룹 451"/>
              <p:cNvGrpSpPr/>
              <p:nvPr/>
            </p:nvGrpSpPr>
            <p:grpSpPr>
              <a:xfrm>
                <a:off x="5174181" y="3163578"/>
                <a:ext cx="315701" cy="184666"/>
                <a:chOff x="514966" y="2755865"/>
                <a:chExt cx="315701" cy="184666"/>
              </a:xfrm>
            </p:grpSpPr>
            <p:cxnSp>
              <p:nvCxnSpPr>
                <p:cNvPr id="453" name="직선 연결선 452"/>
                <p:cNvCxnSpPr/>
                <p:nvPr/>
              </p:nvCxnSpPr>
              <p:spPr>
                <a:xfrm>
                  <a:off x="758667" y="2845277"/>
                  <a:ext cx="7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4" name="TextBox 198"/>
                <p:cNvSpPr txBox="1"/>
                <p:nvPr/>
              </p:nvSpPr>
              <p:spPr>
                <a:xfrm>
                  <a:off x="514966" y="2755865"/>
                  <a:ext cx="314510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ko-KR"/>
                  </a:defPPr>
                  <a:lvl1pPr marL="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6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100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  <p:grpSp>
            <p:nvGrpSpPr>
              <p:cNvPr id="455" name="그룹 454"/>
              <p:cNvGrpSpPr/>
              <p:nvPr/>
            </p:nvGrpSpPr>
            <p:grpSpPr>
              <a:xfrm>
                <a:off x="5217045" y="3471665"/>
                <a:ext cx="272832" cy="184666"/>
                <a:chOff x="562597" y="2839208"/>
                <a:chExt cx="272832" cy="184666"/>
              </a:xfrm>
            </p:grpSpPr>
            <p:cxnSp>
              <p:nvCxnSpPr>
                <p:cNvPr id="456" name="직선 연결선 455"/>
                <p:cNvCxnSpPr/>
                <p:nvPr/>
              </p:nvCxnSpPr>
              <p:spPr>
                <a:xfrm>
                  <a:off x="763429" y="2928620"/>
                  <a:ext cx="7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57" name="TextBox 310"/>
                <p:cNvSpPr txBox="1"/>
                <p:nvPr/>
              </p:nvSpPr>
              <p:spPr>
                <a:xfrm>
                  <a:off x="562597" y="2839208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ko-KR"/>
                  </a:defPPr>
                  <a:lvl1pPr marL="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6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37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  <p:grpSp>
            <p:nvGrpSpPr>
              <p:cNvPr id="458" name="그룹 457"/>
              <p:cNvGrpSpPr/>
              <p:nvPr/>
            </p:nvGrpSpPr>
            <p:grpSpPr>
              <a:xfrm>
                <a:off x="5217039" y="3936144"/>
                <a:ext cx="272832" cy="184666"/>
                <a:chOff x="557835" y="2763008"/>
                <a:chExt cx="272832" cy="184666"/>
              </a:xfrm>
            </p:grpSpPr>
            <p:cxnSp>
              <p:nvCxnSpPr>
                <p:cNvPr id="459" name="직선 연결선 458"/>
                <p:cNvCxnSpPr/>
                <p:nvPr/>
              </p:nvCxnSpPr>
              <p:spPr>
                <a:xfrm>
                  <a:off x="758667" y="2852420"/>
                  <a:ext cx="72000" cy="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460" name="TextBox 310"/>
                <p:cNvSpPr txBox="1"/>
                <p:nvPr/>
              </p:nvSpPr>
              <p:spPr>
                <a:xfrm>
                  <a:off x="557835" y="2763008"/>
                  <a:ext cx="271228" cy="18466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>
                  <a:defPPr>
                    <a:defRPr lang="ko-KR"/>
                  </a:defPPr>
                  <a:lvl1pPr marL="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1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ko-KR" sz="600" b="1" dirty="0" smtClean="0">
                      <a:latin typeface="Arial Unicode MS" pitchFamily="50" charset="-127"/>
                      <a:ea typeface="Arial Unicode MS" pitchFamily="50" charset="-127"/>
                      <a:cs typeface="Arial Unicode MS" pitchFamily="50" charset="-127"/>
                    </a:rPr>
                    <a:t>37</a:t>
                  </a:r>
                  <a:endParaRPr lang="ko-KR" altLang="en-US" sz="600" b="1" dirty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endParaRPr>
                </a:p>
              </p:txBody>
            </p:sp>
          </p:grpSp>
        </p:grpSp>
        <p:cxnSp>
          <p:nvCxnSpPr>
            <p:cNvPr id="497" name="직선 연결선 496"/>
            <p:cNvCxnSpPr/>
            <p:nvPr/>
          </p:nvCxnSpPr>
          <p:spPr>
            <a:xfrm>
              <a:off x="4305378" y="2616774"/>
              <a:ext cx="7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98" name="TextBox 198"/>
            <p:cNvSpPr txBox="1"/>
            <p:nvPr/>
          </p:nvSpPr>
          <p:spPr>
            <a:xfrm>
              <a:off x="4061677" y="2527362"/>
              <a:ext cx="314510" cy="18466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600" b="1" dirty="0" smtClean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rPr>
                <a:t>100</a:t>
              </a:r>
              <a:endParaRPr lang="ko-KR" altLang="en-US" sz="600" b="1" dirty="0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57590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0" name="Picture 6"/>
          <p:cNvPicPr preferRelativeResize="0">
            <a:picLocks noChangeArrowheads="1"/>
          </p:cNvPicPr>
          <p:nvPr/>
        </p:nvPicPr>
        <p:blipFill>
          <a:blip r:embed="rId2" cstate="print"/>
          <a:srcRect l="4162" t="9079" r="5384" b="12400"/>
          <a:stretch>
            <a:fillRect/>
          </a:stretch>
        </p:blipFill>
        <p:spPr bwMode="auto">
          <a:xfrm>
            <a:off x="4015740" y="2362200"/>
            <a:ext cx="1393200" cy="280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pic>
        <p:nvPicPr>
          <p:cNvPr id="1026" name="Picture 2"/>
          <p:cNvPicPr preferRelativeResize="0">
            <a:picLocks noChangeArrowheads="1"/>
          </p:cNvPicPr>
          <p:nvPr/>
        </p:nvPicPr>
        <p:blipFill>
          <a:blip r:embed="rId3" cstate="print">
            <a:lum contrast="10000"/>
          </a:blip>
          <a:srcRect/>
          <a:stretch>
            <a:fillRect/>
          </a:stretch>
        </p:blipFill>
        <p:spPr bwMode="auto">
          <a:xfrm>
            <a:off x="4011613" y="2686050"/>
            <a:ext cx="1411200" cy="262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90" name="직사각형 189"/>
          <p:cNvSpPr/>
          <p:nvPr/>
        </p:nvSpPr>
        <p:spPr>
          <a:xfrm>
            <a:off x="813307" y="4663995"/>
            <a:ext cx="8599751" cy="92333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</a:pPr>
            <a:r>
              <a:rPr lang="en-US" altLang="ko-KR" sz="1200" b="1" dirty="0">
                <a:latin typeface="Times New Roman" pitchFamily="18" charset="0"/>
                <a:cs typeface="Times New Roman" pitchFamily="18" charset="0"/>
              </a:rPr>
              <a:t>Supplemental Figure 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7. </a:t>
            </a:r>
            <a:r>
              <a:rPr lang="en-US" altLang="ko-KR" sz="1200" b="1" dirty="0" err="1" smtClean="0">
                <a:latin typeface="Times New Roman" pitchFamily="18" charset="0"/>
                <a:cs typeface="Times New Roman" pitchFamily="18" charset="0"/>
              </a:rPr>
              <a:t>Thapsigargin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 regulates Axin1 and β-catenin levels through C/EBP-β-dependent mechanism in Huh-7 cells. </a:t>
            </a:r>
          </a:p>
          <a:p>
            <a:pPr algn="just">
              <a:lnSpc>
                <a:spcPct val="150000"/>
              </a:lnSpc>
            </a:pP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Huh-7 cells were infected with pLKO.1 or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shC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/EBP-β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lentiviru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Sigma-Aldrich) and cells were treated with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thapgigargin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(1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μM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), following which whole cell </a:t>
            </a:r>
            <a:r>
              <a:rPr lang="en-US" altLang="ko-KR" sz="1200" dirty="0" err="1" smtClean="0">
                <a:latin typeface="Times New Roman" pitchFamily="18" charset="0"/>
                <a:cs typeface="Times New Roman" pitchFamily="18" charset="0"/>
              </a:rPr>
              <a:t>lysates</a:t>
            </a:r>
            <a:r>
              <a:rPr lang="en-US" altLang="ko-KR" sz="1200" dirty="0" smtClean="0">
                <a:latin typeface="Times New Roman" pitchFamily="18" charset="0"/>
                <a:cs typeface="Times New Roman" pitchFamily="18" charset="0"/>
              </a:rPr>
              <a:t> were subjected to western blot analysis against the indicated antibodies.</a:t>
            </a:r>
            <a:r>
              <a:rPr lang="en-US" altLang="ko-KR" sz="1200" b="1" dirty="0" smtClean="0">
                <a:latin typeface="Times New Roman" pitchFamily="18" charset="0"/>
                <a:cs typeface="Times New Roman" pitchFamily="18" charset="0"/>
              </a:rPr>
              <a:t> </a:t>
            </a:r>
          </a:p>
        </p:txBody>
      </p:sp>
      <p:grpSp>
        <p:nvGrpSpPr>
          <p:cNvPr id="2" name="그룹 460"/>
          <p:cNvGrpSpPr/>
          <p:nvPr/>
        </p:nvGrpSpPr>
        <p:grpSpPr>
          <a:xfrm>
            <a:off x="3629704" y="1947616"/>
            <a:ext cx="2295926" cy="1714987"/>
            <a:chOff x="1976164" y="1553281"/>
            <a:chExt cx="2295926" cy="1714987"/>
          </a:xfrm>
        </p:grpSpPr>
        <p:pic>
          <p:nvPicPr>
            <p:cNvPr id="194" name="Picture 5"/>
            <p:cNvPicPr preferRelativeResize="0">
              <a:picLocks noChangeArrowheads="1"/>
            </p:cNvPicPr>
            <p:nvPr/>
          </p:nvPicPr>
          <p:blipFill>
            <a:blip r:embed="rId4" cstate="print"/>
            <a:srcRect l="3156" t="7670" r="3317"/>
            <a:stretch>
              <a:fillRect/>
            </a:stretch>
          </p:blipFill>
          <p:spPr bwMode="auto">
            <a:xfrm>
              <a:off x="2346801" y="2601392"/>
              <a:ext cx="1402058" cy="3005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96" name="Picture 4"/>
            <p:cNvPicPr>
              <a:picLocks noChangeAspect="1" noChangeArrowheads="1"/>
            </p:cNvPicPr>
            <p:nvPr/>
          </p:nvPicPr>
          <p:blipFill>
            <a:blip r:embed="rId5" cstate="print"/>
            <a:srcRect l="8900" t="-2149" r="1898"/>
            <a:stretch>
              <a:fillRect/>
            </a:stretch>
          </p:blipFill>
          <p:spPr bwMode="auto">
            <a:xfrm>
              <a:off x="2361445" y="2900099"/>
              <a:ext cx="1394659" cy="27338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97" name="TextBox 159"/>
            <p:cNvSpPr txBox="1"/>
            <p:nvPr/>
          </p:nvSpPr>
          <p:spPr>
            <a:xfrm>
              <a:off x="3713910" y="2930880"/>
              <a:ext cx="45557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altLang="ko-KR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β</a:t>
              </a:r>
              <a:r>
                <a:rPr lang="en-US" altLang="ko-KR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actin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98" name="TextBox 160"/>
            <p:cNvSpPr txBox="1"/>
            <p:nvPr/>
          </p:nvSpPr>
          <p:spPr>
            <a:xfrm>
              <a:off x="3719075" y="1983263"/>
              <a:ext cx="534121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C/EBP-β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199" name="TextBox 161"/>
            <p:cNvSpPr txBox="1"/>
            <p:nvPr/>
          </p:nvSpPr>
          <p:spPr>
            <a:xfrm>
              <a:off x="2413033" y="1760512"/>
              <a:ext cx="3328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b="1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00" name="TextBox 162"/>
            <p:cNvSpPr txBox="1"/>
            <p:nvPr/>
          </p:nvSpPr>
          <p:spPr>
            <a:xfrm>
              <a:off x="2715594" y="1767169"/>
              <a:ext cx="2888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b="1" dirty="0" err="1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g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01" name="TextBox 163"/>
            <p:cNvSpPr txBox="1"/>
            <p:nvPr/>
          </p:nvSpPr>
          <p:spPr>
            <a:xfrm>
              <a:off x="3111341" y="1760876"/>
              <a:ext cx="332814" cy="2000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b="1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02" name="TextBox 164"/>
            <p:cNvSpPr txBox="1"/>
            <p:nvPr/>
          </p:nvSpPr>
          <p:spPr>
            <a:xfrm>
              <a:off x="3414865" y="1762685"/>
              <a:ext cx="288862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b="1" dirty="0" err="1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Tg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cxnSp>
          <p:nvCxnSpPr>
            <p:cNvPr id="203" name="직선 연결선 202"/>
            <p:cNvCxnSpPr/>
            <p:nvPr/>
          </p:nvCxnSpPr>
          <p:spPr>
            <a:xfrm>
              <a:off x="2417910" y="1756609"/>
              <a:ext cx="61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4" name="직선 연결선 203"/>
            <p:cNvCxnSpPr/>
            <p:nvPr/>
          </p:nvCxnSpPr>
          <p:spPr>
            <a:xfrm>
              <a:off x="3094679" y="1756611"/>
              <a:ext cx="612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5" name="TextBox 167"/>
            <p:cNvSpPr txBox="1"/>
            <p:nvPr/>
          </p:nvSpPr>
          <p:spPr>
            <a:xfrm>
              <a:off x="2471918" y="1553281"/>
              <a:ext cx="489236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pLKO.1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06" name="TextBox 168"/>
            <p:cNvSpPr txBox="1"/>
            <p:nvPr/>
          </p:nvSpPr>
          <p:spPr>
            <a:xfrm>
              <a:off x="3095754" y="1553281"/>
              <a:ext cx="628698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ko-KR" sz="700" b="1" dirty="0" err="1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shC</a:t>
              </a:r>
              <a:r>
                <a:rPr lang="en-US" altLang="ko-KR" sz="700" b="1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/EBP-β</a:t>
              </a:r>
            </a:p>
          </p:txBody>
        </p:sp>
        <p:sp>
          <p:nvSpPr>
            <p:cNvPr id="207" name="직사각형 206"/>
            <p:cNvSpPr/>
            <p:nvPr/>
          </p:nvSpPr>
          <p:spPr>
            <a:xfrm>
              <a:off x="2355492" y="2918962"/>
              <a:ext cx="1394504" cy="26089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ko-KR" altLang="en-US" sz="700" b="1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208" name="직사각형 207"/>
            <p:cNvSpPr/>
            <p:nvPr/>
          </p:nvSpPr>
          <p:spPr>
            <a:xfrm>
              <a:off x="2355928" y="1970881"/>
              <a:ext cx="1394504" cy="26089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ko-KR" altLang="en-US" sz="700" b="1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209" name="TextBox 171"/>
            <p:cNvSpPr txBox="1"/>
            <p:nvPr/>
          </p:nvSpPr>
          <p:spPr>
            <a:xfrm>
              <a:off x="3717130" y="2622104"/>
              <a:ext cx="554960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l-GR" altLang="ko-KR" sz="700" b="1" dirty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β</a:t>
              </a:r>
              <a:r>
                <a:rPr lang="en-US" altLang="ko-KR" sz="700" b="1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-catenin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sp>
          <p:nvSpPr>
            <p:cNvPr id="210" name="직사각형 209"/>
            <p:cNvSpPr/>
            <p:nvPr/>
          </p:nvSpPr>
          <p:spPr>
            <a:xfrm>
              <a:off x="2356176" y="2605685"/>
              <a:ext cx="1394504" cy="26089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ko-KR" altLang="en-US" sz="700" b="1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211" name="직사각형 210"/>
            <p:cNvSpPr/>
            <p:nvPr/>
          </p:nvSpPr>
          <p:spPr>
            <a:xfrm>
              <a:off x="2359616" y="2285796"/>
              <a:ext cx="1394504" cy="26089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ko-KR" altLang="en-US" sz="700" b="1">
                <a:latin typeface="Arial Unicode MS" pitchFamily="50" charset="-127"/>
                <a:ea typeface="Arial Unicode MS" pitchFamily="50" charset="-127"/>
                <a:cs typeface="Arial Unicode MS" pitchFamily="50" charset="-127"/>
              </a:endParaRPr>
            </a:p>
          </p:txBody>
        </p:sp>
        <p:sp>
          <p:nvSpPr>
            <p:cNvPr id="212" name="TextBox 174"/>
            <p:cNvSpPr txBox="1"/>
            <p:nvPr/>
          </p:nvSpPr>
          <p:spPr>
            <a:xfrm>
              <a:off x="3713838" y="2303427"/>
              <a:ext cx="407484" cy="2000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ko-KR"/>
              </a:defPPr>
              <a:lvl1pPr marL="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1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ko-KR" sz="700" b="1" dirty="0" smtClean="0">
                  <a:latin typeface="Arial Unicode MS" panose="020B0604020202020204" pitchFamily="50" charset="-127"/>
                  <a:ea typeface="Arial Unicode MS" panose="020B0604020202020204" pitchFamily="50" charset="-127"/>
                  <a:cs typeface="Arial Unicode MS" panose="020B0604020202020204" pitchFamily="50" charset="-127"/>
                </a:rPr>
                <a:t>Axin1</a:t>
              </a:r>
              <a:endParaRPr lang="ko-KR" altLang="en-US" sz="700" b="1" dirty="0">
                <a:latin typeface="Arial Unicode MS" panose="020B0604020202020204" pitchFamily="50" charset="-127"/>
                <a:ea typeface="Arial Unicode MS" panose="020B0604020202020204" pitchFamily="50" charset="-127"/>
                <a:cs typeface="Arial Unicode MS" panose="020B0604020202020204" pitchFamily="50" charset="-127"/>
              </a:endParaRPr>
            </a:p>
          </p:txBody>
        </p:sp>
        <p:grpSp>
          <p:nvGrpSpPr>
            <p:cNvPr id="3" name="그룹 180"/>
            <p:cNvGrpSpPr/>
            <p:nvPr/>
          </p:nvGrpSpPr>
          <p:grpSpPr>
            <a:xfrm>
              <a:off x="1976164" y="2404740"/>
              <a:ext cx="334749" cy="184666"/>
              <a:chOff x="484013" y="2763008"/>
              <a:chExt cx="334749" cy="184666"/>
            </a:xfrm>
          </p:grpSpPr>
          <p:cxnSp>
            <p:nvCxnSpPr>
              <p:cNvPr id="191" name="직선 연결선 190"/>
              <p:cNvCxnSpPr/>
              <p:nvPr/>
            </p:nvCxnSpPr>
            <p:spPr>
              <a:xfrm>
                <a:off x="746762" y="2852420"/>
                <a:ext cx="7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92" name="TextBox 198"/>
              <p:cNvSpPr txBox="1"/>
              <p:nvPr/>
            </p:nvSpPr>
            <p:spPr>
              <a:xfrm>
                <a:off x="484013" y="2763008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6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100</a:t>
                </a:r>
                <a:endParaRPr lang="ko-KR" altLang="en-US" sz="6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pSp>
          <p:nvGrpSpPr>
            <p:cNvPr id="4" name="그룹 181"/>
            <p:cNvGrpSpPr/>
            <p:nvPr/>
          </p:nvGrpSpPr>
          <p:grpSpPr>
            <a:xfrm>
              <a:off x="2028553" y="1933362"/>
              <a:ext cx="282356" cy="184666"/>
              <a:chOff x="536406" y="2763008"/>
              <a:chExt cx="282356" cy="184666"/>
            </a:xfrm>
          </p:grpSpPr>
          <p:cxnSp>
            <p:nvCxnSpPr>
              <p:cNvPr id="183" name="직선 연결선 182"/>
              <p:cNvCxnSpPr/>
              <p:nvPr/>
            </p:nvCxnSpPr>
            <p:spPr>
              <a:xfrm>
                <a:off x="746762" y="2852420"/>
                <a:ext cx="7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84" name="TextBox 310"/>
              <p:cNvSpPr txBox="1"/>
              <p:nvPr/>
            </p:nvSpPr>
            <p:spPr>
              <a:xfrm>
                <a:off x="536406" y="2763008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6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50</a:t>
                </a:r>
                <a:endParaRPr lang="ko-KR" altLang="en-US" sz="6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pSp>
          <p:nvGrpSpPr>
            <p:cNvPr id="5" name="그룹 350"/>
            <p:cNvGrpSpPr/>
            <p:nvPr/>
          </p:nvGrpSpPr>
          <p:grpSpPr>
            <a:xfrm>
              <a:off x="2028556" y="3083602"/>
              <a:ext cx="282356" cy="184666"/>
              <a:chOff x="536406" y="2763008"/>
              <a:chExt cx="282356" cy="184666"/>
            </a:xfrm>
          </p:grpSpPr>
          <p:cxnSp>
            <p:nvCxnSpPr>
              <p:cNvPr id="352" name="직선 연결선 351"/>
              <p:cNvCxnSpPr/>
              <p:nvPr/>
            </p:nvCxnSpPr>
            <p:spPr>
              <a:xfrm>
                <a:off x="746762" y="2852420"/>
                <a:ext cx="7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3" name="TextBox 310"/>
              <p:cNvSpPr txBox="1"/>
              <p:nvPr/>
            </p:nvSpPr>
            <p:spPr>
              <a:xfrm>
                <a:off x="536406" y="2763008"/>
                <a:ext cx="271228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6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37</a:t>
                </a:r>
                <a:endParaRPr lang="ko-KR" altLang="en-US" sz="6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  <p:grpSp>
          <p:nvGrpSpPr>
            <p:cNvPr id="6" name="그룹 353"/>
            <p:cNvGrpSpPr/>
            <p:nvPr/>
          </p:nvGrpSpPr>
          <p:grpSpPr>
            <a:xfrm>
              <a:off x="1976172" y="2646812"/>
              <a:ext cx="334749" cy="184666"/>
              <a:chOff x="484013" y="2763008"/>
              <a:chExt cx="334749" cy="184666"/>
            </a:xfrm>
          </p:grpSpPr>
          <p:cxnSp>
            <p:nvCxnSpPr>
              <p:cNvPr id="355" name="직선 연결선 354"/>
              <p:cNvCxnSpPr/>
              <p:nvPr/>
            </p:nvCxnSpPr>
            <p:spPr>
              <a:xfrm>
                <a:off x="746762" y="2852420"/>
                <a:ext cx="720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56" name="TextBox 198"/>
              <p:cNvSpPr txBox="1"/>
              <p:nvPr/>
            </p:nvSpPr>
            <p:spPr>
              <a:xfrm>
                <a:off x="484013" y="2763008"/>
                <a:ext cx="314510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ko-KR" sz="600" b="1" dirty="0" smtClean="0">
                    <a:latin typeface="Arial Unicode MS" pitchFamily="50" charset="-127"/>
                    <a:ea typeface="Arial Unicode MS" pitchFamily="50" charset="-127"/>
                    <a:cs typeface="Arial Unicode MS" pitchFamily="50" charset="-127"/>
                  </a:rPr>
                  <a:t>100</a:t>
                </a:r>
                <a:endParaRPr lang="ko-KR" altLang="en-US" sz="600" b="1" dirty="0">
                  <a:latin typeface="Arial Unicode MS" pitchFamily="50" charset="-127"/>
                  <a:ea typeface="Arial Unicode MS" pitchFamily="50" charset="-127"/>
                  <a:cs typeface="Arial Unicode MS" pitchFamily="50" charset="-127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5759028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824</TotalTime>
  <Words>555</Words>
  <Application>Microsoft Office PowerPoint</Application>
  <PresentationFormat>A4 용지(210x297mm)</PresentationFormat>
  <Paragraphs>167</Paragraphs>
  <Slides>7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7</vt:i4>
      </vt:variant>
    </vt:vector>
  </HeadingPairs>
  <TitlesOfParts>
    <vt:vector size="8" baseType="lpstr"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Y</dc:creator>
  <cp:lastModifiedBy>OST</cp:lastModifiedBy>
  <cp:revision>41</cp:revision>
  <dcterms:created xsi:type="dcterms:W3CDTF">2016-10-28T01:47:02Z</dcterms:created>
  <dcterms:modified xsi:type="dcterms:W3CDTF">2018-09-10T08:03:53Z</dcterms:modified>
</cp:coreProperties>
</file>